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wdp" ContentType="image/vnd.ms-photo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81" r:id="rId5"/>
    <p:sldId id="271" r:id="rId6"/>
    <p:sldId id="275" r:id="rId7"/>
    <p:sldId id="276" r:id="rId8"/>
    <p:sldId id="279" r:id="rId9"/>
    <p:sldId id="280" r:id="rId10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232" y="-5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'Leaf wash'!$G$3:$G$14</c:f>
                <c:numCache>
                  <c:formatCode>General</c:formatCode>
                  <c:ptCount val="12"/>
                  <c:pt idx="0">
                    <c:v>4.0000000000000036E-3</c:v>
                  </c:pt>
                  <c:pt idx="1">
                    <c:v>6.0000000000000062E-3</c:v>
                  </c:pt>
                  <c:pt idx="2">
                    <c:v>7.0000000000000062E-3</c:v>
                  </c:pt>
                  <c:pt idx="3">
                    <c:v>5.0000000000000034E-4</c:v>
                  </c:pt>
                  <c:pt idx="4">
                    <c:v>1.0000000000000009E-3</c:v>
                  </c:pt>
                  <c:pt idx="5">
                    <c:v>6.0000000000000032E-2</c:v>
                  </c:pt>
                  <c:pt idx="6">
                    <c:v>3.0000000000000035E-4</c:v>
                  </c:pt>
                  <c:pt idx="7">
                    <c:v>3.0000000000000035E-4</c:v>
                  </c:pt>
                  <c:pt idx="8">
                    <c:v>5.0000000000000034E-4</c:v>
                  </c:pt>
                  <c:pt idx="9">
                    <c:v>8.0000000000000069E-4</c:v>
                  </c:pt>
                  <c:pt idx="10">
                    <c:v>8.0000000000000069E-4</c:v>
                  </c:pt>
                  <c:pt idx="11">
                    <c:v>1.0000000000000009E-3</c:v>
                  </c:pt>
                </c:numCache>
              </c:numRef>
            </c:plus>
            <c:minus>
              <c:numRef>
                <c:f>'Leaf wash'!$G$3:$G$14</c:f>
                <c:numCache>
                  <c:formatCode>General</c:formatCode>
                  <c:ptCount val="12"/>
                  <c:pt idx="0">
                    <c:v>4.0000000000000036E-3</c:v>
                  </c:pt>
                  <c:pt idx="1">
                    <c:v>6.0000000000000062E-3</c:v>
                  </c:pt>
                  <c:pt idx="2">
                    <c:v>7.0000000000000062E-3</c:v>
                  </c:pt>
                  <c:pt idx="3">
                    <c:v>5.0000000000000034E-4</c:v>
                  </c:pt>
                  <c:pt idx="4">
                    <c:v>1.0000000000000009E-3</c:v>
                  </c:pt>
                  <c:pt idx="5">
                    <c:v>6.0000000000000032E-2</c:v>
                  </c:pt>
                  <c:pt idx="6">
                    <c:v>3.0000000000000035E-4</c:v>
                  </c:pt>
                  <c:pt idx="7">
                    <c:v>3.0000000000000035E-4</c:v>
                  </c:pt>
                  <c:pt idx="8">
                    <c:v>5.0000000000000034E-4</c:v>
                  </c:pt>
                  <c:pt idx="9">
                    <c:v>8.0000000000000069E-4</c:v>
                  </c:pt>
                  <c:pt idx="10">
                    <c:v>8.0000000000000069E-4</c:v>
                  </c:pt>
                  <c:pt idx="11">
                    <c:v>1.0000000000000009E-3</c:v>
                  </c:pt>
                </c:numCache>
              </c:numRef>
            </c:minus>
          </c:errBars>
          <c:cat>
            <c:strRef>
              <c:f>'Leaf wash'!$E$3:$E$14</c:f>
              <c:strCache>
                <c:ptCount val="12"/>
                <c:pt idx="0">
                  <c:v>O. rhizomatis</c:v>
                </c:pt>
                <c:pt idx="1">
                  <c:v>O. eichingeri</c:v>
                </c:pt>
                <c:pt idx="2">
                  <c:v>O. minuta</c:v>
                </c:pt>
                <c:pt idx="3">
                  <c:v>O. latifolia</c:v>
                </c:pt>
                <c:pt idx="4">
                  <c:v>O. alta</c:v>
                </c:pt>
                <c:pt idx="5">
                  <c:v>O. coarctata</c:v>
                </c:pt>
                <c:pt idx="6">
                  <c:v>O. grandiglumis</c:v>
                </c:pt>
                <c:pt idx="7">
                  <c:v>IR75862-206-2-8-3</c:v>
                </c:pt>
                <c:pt idx="8">
                  <c:v>IR29</c:v>
                </c:pt>
                <c:pt idx="9">
                  <c:v>FL478</c:v>
                </c:pt>
                <c:pt idx="10">
                  <c:v>Pokkali </c:v>
                </c:pt>
                <c:pt idx="11">
                  <c:v>Nona Bokra</c:v>
                </c:pt>
              </c:strCache>
            </c:strRef>
          </c:cat>
          <c:val>
            <c:numRef>
              <c:f>'Leaf wash'!$F$3:$F$14</c:f>
              <c:numCache>
                <c:formatCode>0.000</c:formatCode>
                <c:ptCount val="12"/>
                <c:pt idx="0">
                  <c:v>5.0000000000000036E-3</c:v>
                </c:pt>
                <c:pt idx="1">
                  <c:v>8.0000000000000088E-3</c:v>
                </c:pt>
                <c:pt idx="2">
                  <c:v>5.0000000000000036E-3</c:v>
                </c:pt>
                <c:pt idx="3">
                  <c:v>9.0000000000000097E-3</c:v>
                </c:pt>
                <c:pt idx="4">
                  <c:v>8.0000000000000088E-3</c:v>
                </c:pt>
                <c:pt idx="5">
                  <c:v>0.56249567893333363</c:v>
                </c:pt>
                <c:pt idx="6">
                  <c:v>6.0000000000000062E-3</c:v>
                </c:pt>
                <c:pt idx="7">
                  <c:v>6.0000000000000062E-3</c:v>
                </c:pt>
                <c:pt idx="8">
                  <c:v>5.3757871042071281E-3</c:v>
                </c:pt>
                <c:pt idx="9">
                  <c:v>5.8571428571428585E-3</c:v>
                </c:pt>
                <c:pt idx="10">
                  <c:v>4.9147271170526391E-3</c:v>
                </c:pt>
                <c:pt idx="11">
                  <c:v>5.1142857142857136E-3</c:v>
                </c:pt>
              </c:numCache>
            </c:numRef>
          </c:val>
        </c:ser>
        <c:axId val="172578688"/>
        <c:axId val="172580224"/>
      </c:barChart>
      <c:catAx>
        <c:axId val="172578688"/>
        <c:scaling>
          <c:orientation val="minMax"/>
        </c:scaling>
        <c:axPos val="b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72580224"/>
        <c:crosses val="autoZero"/>
        <c:auto val="1"/>
        <c:lblAlgn val="ctr"/>
        <c:lblOffset val="100"/>
      </c:catAx>
      <c:valAx>
        <c:axId val="172580224"/>
        <c:scaling>
          <c:orientation val="minMax"/>
        </c:scaling>
        <c:axPos val="l"/>
        <c:majorGridlines>
          <c:spPr>
            <a:ln>
              <a:noFill/>
            </a:ln>
          </c:spPr>
        </c:majorGridlines>
        <c:numFmt formatCode="0.000" sourceLinked="1"/>
        <c:tickLblPos val="nextTo"/>
        <c:crossAx val="172578688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fil-P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C04E1BAA-238F-4F4C-A112-6E891AC439A4}" type="datetimeFigureOut">
              <a:rPr lang="fil-PH" smtClean="0"/>
              <a:pPr/>
              <a:t>3/27/2018</a:t>
            </a:fld>
            <a:endParaRPr lang="fil-P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13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fil-P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l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fil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410949E6-4813-47E9-A3A1-E9711BFADEE0}" type="slidenum">
              <a:rPr lang="fil-PH" smtClean="0"/>
              <a:pPr/>
              <a:t>‹#›</a:t>
            </a:fld>
            <a:endParaRPr lang="fil-PH"/>
          </a:p>
        </p:txBody>
      </p:sp>
    </p:spTree>
    <p:extLst>
      <p:ext uri="{BB962C8B-B14F-4D97-AF65-F5344CB8AC3E}">
        <p14:creationId xmlns:p14="http://schemas.microsoft.com/office/powerpoint/2010/main" xmlns="" val="1933625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il-P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0949E6-4813-47E9-A3A1-E9711BFADEE0}" type="slidenum">
              <a:rPr lang="fil-PH" smtClean="0"/>
              <a:pPr/>
              <a:t>2</a:t>
            </a:fld>
            <a:endParaRPr lang="fil-PH"/>
          </a:p>
        </p:txBody>
      </p:sp>
    </p:spTree>
    <p:extLst>
      <p:ext uri="{BB962C8B-B14F-4D97-AF65-F5344CB8AC3E}">
        <p14:creationId xmlns:p14="http://schemas.microsoft.com/office/powerpoint/2010/main" xmlns="" val="1972306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018-03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158323540"/>
              </p:ext>
            </p:extLst>
          </p:nvPr>
        </p:nvGraphicFramePr>
        <p:xfrm>
          <a:off x="457200" y="990600"/>
          <a:ext cx="7772400" cy="3154230"/>
        </p:xfrm>
        <a:graphic>
          <a:graphicData uri="http://schemas.openxmlformats.org/drawingml/2006/table">
            <a:tbl>
              <a:tblPr/>
              <a:tblGrid>
                <a:gridCol w="1755162"/>
                <a:gridCol w="958242"/>
                <a:gridCol w="1793879"/>
                <a:gridCol w="2064896"/>
                <a:gridCol w="1200221"/>
              </a:tblGrid>
              <a:tr h="1594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e / MSU Locus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 ID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 name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Forward primer  (5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´ to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´)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everse primer  (5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´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to 3´) 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oduct size  (bp)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NHX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Os07g47100)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sNX1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TGGTGATCTTGCTGATGA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TAGCCATGGCTTACCAA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311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sNX2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CTTCCGTGAGTTGGTAGT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TCCCAACATACAGGAA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307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sNX3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GCGGCATTCTCACCGTAT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ATGCGCAATTCGACATGA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313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sNX4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GTACACGACCTCCGACTA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TGCATTGAAGATGATCG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050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OsNX5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*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ACGCATTTGCAACTCTG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AAGAACGACAGCGGGA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5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KT1;4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Os04g51830)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4F1 *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TCTACATCGTGCTCGCC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TCTCGTTCGTCGGCATGAA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9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4F2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TCCTACCTGACCATCTT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GTCTACTGCAACTGTAG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285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KT1;5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Os01g20160)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F1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GGGAGAGGGAGAAGAAG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CCTTGAGGGTACATAC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227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OsHF2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CGTGGATGTGGATTTT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GTGTCGATGTCCTAAAC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339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F3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ACACACCGATGTTGACTT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GTACTCTGGCCTGGGAC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6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F4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CGTGTGAGTAGTAGTGCA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TGGCTAGTAGTGTTCAT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8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F5*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ACCACTTTCGTACCTGT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ATAACCTCGACGACGATG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1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HF6*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CCGATGAAGACCAGCAT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ACCCCATCACCACGAAC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4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OsSOS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Os12g44360)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OS1F1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GCACAAAACATGGCATG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AGCCAGAAGAAGATCAG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4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OS1F2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GCACAAAACATGGCATG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TCCAGCAAGTAACACCAT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8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1894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OS1F3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GCACAAAACATGGCATG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GCCAAGTTCTTTTAGCA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8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94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SOS1F4*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ACAATTCTTGTTTGGGC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AAACACGATGCCACCAGTG  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45</a:t>
                      </a:r>
                    </a:p>
                  </a:txBody>
                  <a:tcPr marL="7595" marR="7595" marT="759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20862" y="5029200"/>
            <a:ext cx="407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</a:t>
            </a:r>
            <a:r>
              <a:rPr lang="fil-PH" dirty="0" smtClean="0"/>
              <a:t>1: Table </a:t>
            </a:r>
            <a:r>
              <a:rPr lang="fil-PH" dirty="0"/>
              <a:t>S1</a:t>
            </a:r>
            <a:r>
              <a:rPr lang="fil-PH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il-PH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09600" y="5410200"/>
            <a:ext cx="81534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 smtClean="0"/>
              <a:t>Designed primer sets </a:t>
            </a:r>
            <a:r>
              <a:rPr lang="fil-PH" sz="1600" dirty="0"/>
              <a:t>for </a:t>
            </a:r>
            <a:r>
              <a:rPr lang="fil-PH" sz="1600" dirty="0" smtClean="0"/>
              <a:t>amplification of the salt tolerance-related genes of rice. </a:t>
            </a:r>
          </a:p>
          <a:p>
            <a:r>
              <a:rPr lang="fil-PH" sz="1600" dirty="0" smtClean="0"/>
              <a:t>*Primers sets  also uesed for qRT-PCR.</a:t>
            </a:r>
            <a:endParaRPr lang="fil-PH" sz="1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57573" y="228605"/>
            <a:ext cx="1828800" cy="1828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005424" y="228603"/>
            <a:ext cx="18288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859751" y="228605"/>
            <a:ext cx="1828800" cy="18287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721603" y="228600"/>
            <a:ext cx="1828800" cy="182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157574" y="2073919"/>
            <a:ext cx="1828800" cy="182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005424" y="2073920"/>
            <a:ext cx="1828800" cy="18287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59751" y="2073920"/>
            <a:ext cx="1828800" cy="18287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6723032" y="3921769"/>
            <a:ext cx="1828801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1157573" y="3921769"/>
            <a:ext cx="18288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6721603" y="2076453"/>
            <a:ext cx="18288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005424" y="3921769"/>
            <a:ext cx="18288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859751" y="3921769"/>
            <a:ext cx="1828800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Rectangle 13"/>
          <p:cNvSpPr/>
          <p:nvPr/>
        </p:nvSpPr>
        <p:spPr>
          <a:xfrm>
            <a:off x="1196144" y="1783272"/>
            <a:ext cx="89319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rhizomatis</a:t>
            </a:r>
            <a:endParaRPr lang="fil-PH" sz="1000" b="1" dirty="0">
              <a:solidFill>
                <a:schemeClr val="bg1"/>
              </a:solidFill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2753758" y="1553705"/>
            <a:ext cx="215444" cy="497233"/>
            <a:chOff x="1712871" y="1375249"/>
            <a:chExt cx="215444" cy="497233"/>
          </a:xfrm>
        </p:grpSpPr>
        <p:sp>
          <p:nvSpPr>
            <p:cNvPr id="16" name="TextBox 15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/>
          <p:cNvGrpSpPr/>
          <p:nvPr/>
        </p:nvGrpSpPr>
        <p:grpSpPr>
          <a:xfrm>
            <a:off x="4618780" y="1553705"/>
            <a:ext cx="215444" cy="497233"/>
            <a:chOff x="1712871" y="1375249"/>
            <a:chExt cx="215444" cy="497233"/>
          </a:xfrm>
        </p:grpSpPr>
        <p:sp>
          <p:nvSpPr>
            <p:cNvPr id="19" name="TextBox 18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6473107" y="1553706"/>
            <a:ext cx="215444" cy="497233"/>
            <a:chOff x="1712871" y="1375249"/>
            <a:chExt cx="215444" cy="497233"/>
          </a:xfrm>
        </p:grpSpPr>
        <p:sp>
          <p:nvSpPr>
            <p:cNvPr id="22" name="TextBox 21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/>
          <p:cNvGrpSpPr/>
          <p:nvPr/>
        </p:nvGrpSpPr>
        <p:grpSpPr>
          <a:xfrm>
            <a:off x="8334959" y="1534655"/>
            <a:ext cx="215444" cy="497233"/>
            <a:chOff x="1712871" y="1375249"/>
            <a:chExt cx="215444" cy="497233"/>
          </a:xfrm>
        </p:grpSpPr>
        <p:sp>
          <p:nvSpPr>
            <p:cNvPr id="25" name="TextBox 24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6" name="Straight Connector 25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oup 26"/>
          <p:cNvGrpSpPr/>
          <p:nvPr/>
        </p:nvGrpSpPr>
        <p:grpSpPr>
          <a:xfrm>
            <a:off x="2756039" y="3405486"/>
            <a:ext cx="215444" cy="497233"/>
            <a:chOff x="1712871" y="1375249"/>
            <a:chExt cx="215444" cy="497233"/>
          </a:xfrm>
        </p:grpSpPr>
        <p:sp>
          <p:nvSpPr>
            <p:cNvPr id="28" name="TextBox 27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29" name="Straight Connector 28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/>
          <p:cNvGrpSpPr/>
          <p:nvPr/>
        </p:nvGrpSpPr>
        <p:grpSpPr>
          <a:xfrm>
            <a:off x="4584838" y="3405486"/>
            <a:ext cx="215444" cy="497233"/>
            <a:chOff x="1712871" y="1375249"/>
            <a:chExt cx="215444" cy="497233"/>
          </a:xfrm>
        </p:grpSpPr>
        <p:sp>
          <p:nvSpPr>
            <p:cNvPr id="31" name="TextBox 30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2" name="Straight Connector 31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/>
          <p:cNvGrpSpPr/>
          <p:nvPr/>
        </p:nvGrpSpPr>
        <p:grpSpPr>
          <a:xfrm>
            <a:off x="6367264" y="3257545"/>
            <a:ext cx="215444" cy="645174"/>
            <a:chOff x="1712871" y="1227308"/>
            <a:chExt cx="215444" cy="645174"/>
          </a:xfrm>
        </p:grpSpPr>
        <p:sp>
          <p:nvSpPr>
            <p:cNvPr id="34" name="TextBox 33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5" name="Straight Connector 34"/>
            <p:cNvCxnSpPr/>
            <p:nvPr/>
          </p:nvCxnSpPr>
          <p:spPr>
            <a:xfrm flipH="1" flipV="1">
              <a:off x="1817773" y="1227308"/>
              <a:ext cx="1880" cy="55138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/>
          <p:cNvGrpSpPr/>
          <p:nvPr/>
        </p:nvGrpSpPr>
        <p:grpSpPr>
          <a:xfrm>
            <a:off x="8301017" y="3435822"/>
            <a:ext cx="215444" cy="497233"/>
            <a:chOff x="1712871" y="1375249"/>
            <a:chExt cx="215444" cy="497233"/>
          </a:xfrm>
        </p:grpSpPr>
        <p:sp>
          <p:nvSpPr>
            <p:cNvPr id="37" name="TextBox 36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 flipV="1">
              <a:off x="1753399" y="1485947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/>
          <p:cNvGrpSpPr/>
          <p:nvPr/>
        </p:nvGrpSpPr>
        <p:grpSpPr>
          <a:xfrm>
            <a:off x="2674473" y="5198120"/>
            <a:ext cx="215444" cy="497233"/>
            <a:chOff x="1712871" y="1375249"/>
            <a:chExt cx="215444" cy="497233"/>
          </a:xfrm>
        </p:grpSpPr>
        <p:sp>
          <p:nvSpPr>
            <p:cNvPr id="40" name="TextBox 39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41" name="Straight Connector 40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/>
          <p:cNvGrpSpPr/>
          <p:nvPr/>
        </p:nvGrpSpPr>
        <p:grpSpPr>
          <a:xfrm>
            <a:off x="4584837" y="5198120"/>
            <a:ext cx="215444" cy="497233"/>
            <a:chOff x="1712871" y="1375249"/>
            <a:chExt cx="215444" cy="497233"/>
          </a:xfrm>
        </p:grpSpPr>
        <p:sp>
          <p:nvSpPr>
            <p:cNvPr id="43" name="TextBox 42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44" name="Straight Connector 43"/>
            <p:cNvCxnSpPr/>
            <p:nvPr/>
          </p:nvCxnSpPr>
          <p:spPr>
            <a:xfrm flipV="1">
              <a:off x="1714750" y="1529709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/>
          <p:cNvGrpSpPr/>
          <p:nvPr/>
        </p:nvGrpSpPr>
        <p:grpSpPr>
          <a:xfrm>
            <a:off x="6411402" y="5281911"/>
            <a:ext cx="215444" cy="497233"/>
            <a:chOff x="1712871" y="1375249"/>
            <a:chExt cx="215444" cy="497233"/>
          </a:xfrm>
        </p:grpSpPr>
        <p:sp>
          <p:nvSpPr>
            <p:cNvPr id="46" name="TextBox 45"/>
            <p:cNvSpPr txBox="1"/>
            <p:nvPr/>
          </p:nvSpPr>
          <p:spPr>
            <a:xfrm rot="16200000">
              <a:off x="1571976" y="1516144"/>
              <a:ext cx="4972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il-PH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47" name="Straight Connector 46"/>
            <p:cNvCxnSpPr/>
            <p:nvPr/>
          </p:nvCxnSpPr>
          <p:spPr>
            <a:xfrm flipV="1">
              <a:off x="1773635" y="1443348"/>
              <a:ext cx="0" cy="24898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0" name="Straight Connector 49"/>
          <p:cNvCxnSpPr/>
          <p:nvPr/>
        </p:nvCxnSpPr>
        <p:spPr>
          <a:xfrm flipV="1">
            <a:off x="8354204" y="5365022"/>
            <a:ext cx="0" cy="248987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3041869" y="1807787"/>
            <a:ext cx="85311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eichingeri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2" name="Rectangle 51"/>
          <p:cNvSpPr/>
          <p:nvPr/>
        </p:nvSpPr>
        <p:spPr>
          <a:xfrm>
            <a:off x="4866788" y="1807787"/>
            <a:ext cx="7136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minuta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6732557" y="1826051"/>
            <a:ext cx="74732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latifolia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224719" y="3654103"/>
            <a:ext cx="54373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alta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3041869" y="3654103"/>
            <a:ext cx="10310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grandiglumis</a:t>
            </a:r>
            <a:endParaRPr lang="fil-PH" sz="1000" b="1" i="1" dirty="0">
              <a:solidFill>
                <a:schemeClr val="bg1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4857263" y="3654103"/>
            <a:ext cx="84189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i="1" dirty="0">
                <a:solidFill>
                  <a:schemeClr val="bg1"/>
                </a:solidFill>
              </a:rPr>
              <a:t>O</a:t>
            </a:r>
            <a:r>
              <a:rPr lang="fil-PH" sz="1000" b="1" i="1" dirty="0" smtClean="0">
                <a:solidFill>
                  <a:schemeClr val="bg1"/>
                </a:solidFill>
              </a:rPr>
              <a:t>. coarctata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6732557" y="3654103"/>
            <a:ext cx="57099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dirty="0" smtClean="0">
                <a:solidFill>
                  <a:schemeClr val="bg1"/>
                </a:solidFill>
              </a:rPr>
              <a:t>Pokkali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1157574" y="5489516"/>
            <a:ext cx="4956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dirty="0" smtClean="0">
                <a:solidFill>
                  <a:schemeClr val="bg1"/>
                </a:solidFill>
              </a:rPr>
              <a:t>FL478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3003769" y="5524205"/>
            <a:ext cx="80823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dirty="0" smtClean="0">
                <a:solidFill>
                  <a:schemeClr val="bg1"/>
                </a:solidFill>
              </a:rPr>
              <a:t>Nona Bokra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4869276" y="5487189"/>
            <a:ext cx="11673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dirty="0" smtClean="0">
                <a:solidFill>
                  <a:schemeClr val="bg1"/>
                </a:solidFill>
              </a:rPr>
              <a:t>IR75862-206-2-8-3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6732557" y="5462202"/>
            <a:ext cx="42191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1000" b="1" dirty="0" smtClean="0">
                <a:solidFill>
                  <a:schemeClr val="bg1"/>
                </a:solidFill>
              </a:rPr>
              <a:t>IR29</a:t>
            </a:r>
            <a:endParaRPr lang="fil-PH" sz="1000" b="1" dirty="0">
              <a:solidFill>
                <a:schemeClr val="bg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12002" y="5879068"/>
            <a:ext cx="407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2: Figure S1</a:t>
            </a:r>
            <a:r>
              <a:rPr lang="fil-PH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il-PH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04800" y="6172200"/>
            <a:ext cx="82296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 smtClean="0"/>
              <a:t>Salt tolerant wild species and check lines after 10 days of growth in normal Yoshida solution. </a:t>
            </a:r>
            <a:r>
              <a:rPr lang="fil-PH" sz="1600" dirty="0"/>
              <a:t>Scale bar=5 </a:t>
            </a:r>
            <a:r>
              <a:rPr lang="fil-PH" sz="1600" dirty="0" smtClean="0"/>
              <a:t>cm.</a:t>
            </a:r>
            <a:endParaRPr lang="fil-PH" sz="1600" dirty="0"/>
          </a:p>
        </p:txBody>
      </p:sp>
    </p:spTree>
    <p:extLst>
      <p:ext uri="{BB962C8B-B14F-4D97-AF65-F5344CB8AC3E}">
        <p14:creationId xmlns:p14="http://schemas.microsoft.com/office/powerpoint/2010/main" xmlns="" val="2071024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073159646"/>
              </p:ext>
            </p:extLst>
          </p:nvPr>
        </p:nvGraphicFramePr>
        <p:xfrm>
          <a:off x="282171" y="1580028"/>
          <a:ext cx="3008642" cy="990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1168"/>
                <a:gridCol w="236668"/>
                <a:gridCol w="236668"/>
                <a:gridCol w="236668"/>
                <a:gridCol w="236668"/>
                <a:gridCol w="236668"/>
                <a:gridCol w="236668"/>
                <a:gridCol w="236668"/>
                <a:gridCol w="236668"/>
                <a:gridCol w="236668"/>
                <a:gridCol w="236668"/>
                <a:gridCol w="236668"/>
                <a:gridCol w="204126"/>
              </a:tblGrid>
              <a:tr h="990600"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0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DNA Ladder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rhizomat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eichingeri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minu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latifoli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al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coarcta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grandiglum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IR29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FL478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Pokkali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Nona Bokra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Niponbare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pSp>
        <p:nvGrpSpPr>
          <p:cNvPr id="5" name="Group 50"/>
          <p:cNvGrpSpPr/>
          <p:nvPr/>
        </p:nvGrpSpPr>
        <p:grpSpPr>
          <a:xfrm>
            <a:off x="776832" y="915622"/>
            <a:ext cx="228600" cy="152409"/>
            <a:chOff x="838200" y="2286000"/>
            <a:chExt cx="228600" cy="152409"/>
          </a:xfrm>
        </p:grpSpPr>
        <p:cxnSp>
          <p:nvCxnSpPr>
            <p:cNvPr id="52" name="Straight Connector 51"/>
            <p:cNvCxnSpPr/>
            <p:nvPr/>
          </p:nvCxnSpPr>
          <p:spPr>
            <a:xfrm flipV="1">
              <a:off x="838200" y="2286000"/>
              <a:ext cx="0" cy="1524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>
              <a:off x="838200" y="2286000"/>
              <a:ext cx="2286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3" name="Rectangle 2"/>
          <p:cNvSpPr/>
          <p:nvPr/>
        </p:nvSpPr>
        <p:spPr>
          <a:xfrm rot="10800000">
            <a:off x="534776" y="1136082"/>
            <a:ext cx="3108960" cy="76201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" name="Rectangle 3"/>
          <p:cNvSpPr/>
          <p:nvPr/>
        </p:nvSpPr>
        <p:spPr>
          <a:xfrm rot="10800000">
            <a:off x="1871163" y="1059873"/>
            <a:ext cx="152400" cy="228600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2" name="Rectangle 31"/>
          <p:cNvSpPr/>
          <p:nvPr/>
        </p:nvSpPr>
        <p:spPr>
          <a:xfrm rot="10800000">
            <a:off x="719694" y="1059882"/>
            <a:ext cx="13335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3" name="Rectangle 32"/>
          <p:cNvSpPr/>
          <p:nvPr/>
        </p:nvSpPr>
        <p:spPr>
          <a:xfrm rot="10800000">
            <a:off x="891132" y="1059875"/>
            <a:ext cx="66675" cy="228604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4" name="Rectangle 33"/>
          <p:cNvSpPr/>
          <p:nvPr/>
        </p:nvSpPr>
        <p:spPr>
          <a:xfrm rot="10800000">
            <a:off x="1510267" y="1059879"/>
            <a:ext cx="7620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5" name="Rectangle 34"/>
          <p:cNvSpPr/>
          <p:nvPr/>
        </p:nvSpPr>
        <p:spPr>
          <a:xfrm rot="10800000">
            <a:off x="1634086" y="1059879"/>
            <a:ext cx="7620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6" name="Rectangle 35"/>
          <p:cNvSpPr/>
          <p:nvPr/>
        </p:nvSpPr>
        <p:spPr>
          <a:xfrm rot="10800000">
            <a:off x="1786493" y="1059882"/>
            <a:ext cx="45719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7" name="Rectangle 36"/>
          <p:cNvSpPr/>
          <p:nvPr/>
        </p:nvSpPr>
        <p:spPr>
          <a:xfrm rot="10800000">
            <a:off x="2059065" y="1059871"/>
            <a:ext cx="45719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8" name="Rectangle 37"/>
          <p:cNvSpPr/>
          <p:nvPr/>
        </p:nvSpPr>
        <p:spPr>
          <a:xfrm rot="10800000">
            <a:off x="2243694" y="1059871"/>
            <a:ext cx="7620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39" name="Rectangle 38"/>
          <p:cNvSpPr/>
          <p:nvPr/>
        </p:nvSpPr>
        <p:spPr>
          <a:xfrm rot="10800000">
            <a:off x="2143287" y="1059883"/>
            <a:ext cx="45719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0" name="Rectangle 39"/>
          <p:cNvSpPr/>
          <p:nvPr/>
        </p:nvSpPr>
        <p:spPr>
          <a:xfrm rot="10800000">
            <a:off x="2386569" y="1059859"/>
            <a:ext cx="7620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1" name="Rectangle 40"/>
          <p:cNvSpPr/>
          <p:nvPr/>
        </p:nvSpPr>
        <p:spPr>
          <a:xfrm rot="10800000">
            <a:off x="2500869" y="1059859"/>
            <a:ext cx="76200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2" name="Rectangle 41"/>
          <p:cNvSpPr/>
          <p:nvPr/>
        </p:nvSpPr>
        <p:spPr>
          <a:xfrm rot="10800000">
            <a:off x="2637627" y="1059847"/>
            <a:ext cx="45719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3" name="Rectangle 42"/>
          <p:cNvSpPr/>
          <p:nvPr/>
        </p:nvSpPr>
        <p:spPr>
          <a:xfrm rot="10800000">
            <a:off x="2767568" y="1059859"/>
            <a:ext cx="45719" cy="228602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44" name="Rectangle 43"/>
          <p:cNvSpPr/>
          <p:nvPr/>
        </p:nvSpPr>
        <p:spPr>
          <a:xfrm rot="10800000">
            <a:off x="3148569" y="1050347"/>
            <a:ext cx="228600" cy="276235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cxnSp>
        <p:nvCxnSpPr>
          <p:cNvPr id="54" name="Straight Connector 53"/>
          <p:cNvCxnSpPr/>
          <p:nvPr/>
        </p:nvCxnSpPr>
        <p:spPr>
          <a:xfrm flipV="1">
            <a:off x="3262425" y="974187"/>
            <a:ext cx="0" cy="1524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949201" y="779760"/>
            <a:ext cx="666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art</a:t>
            </a:r>
            <a:endParaRPr lang="fil-PH" sz="1100" dirty="0"/>
          </a:p>
        </p:txBody>
      </p:sp>
      <p:sp>
        <p:nvSpPr>
          <p:cNvPr id="58" name="TextBox 57"/>
          <p:cNvSpPr txBox="1"/>
          <p:nvPr/>
        </p:nvSpPr>
        <p:spPr>
          <a:xfrm>
            <a:off x="3043066" y="760855"/>
            <a:ext cx="8073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op</a:t>
            </a:r>
            <a:endParaRPr lang="fil-PH" sz="1100" dirty="0"/>
          </a:p>
        </p:txBody>
      </p:sp>
      <p:sp>
        <p:nvSpPr>
          <p:cNvPr id="163" name="Rectangle 162"/>
          <p:cNvSpPr/>
          <p:nvPr/>
        </p:nvSpPr>
        <p:spPr>
          <a:xfrm>
            <a:off x="1005432" y="1144705"/>
            <a:ext cx="49725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NX1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891131" y="269454"/>
            <a:ext cx="10452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600" b="1" i="1" dirty="0" smtClean="0"/>
              <a:t>OsNHX1</a:t>
            </a:r>
            <a:endParaRPr lang="fil-PH" sz="1600" b="1" i="1" dirty="0"/>
          </a:p>
        </p:txBody>
      </p:sp>
      <p:sp>
        <p:nvSpPr>
          <p:cNvPr id="92" name="TextBox 91"/>
          <p:cNvSpPr txBox="1"/>
          <p:nvPr/>
        </p:nvSpPr>
        <p:spPr>
          <a:xfrm>
            <a:off x="457200" y="207898"/>
            <a:ext cx="5004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l-PH" sz="2000" b="1" dirty="0" smtClean="0"/>
              <a:t>(A)</a:t>
            </a:r>
            <a:endParaRPr lang="fil-PH" sz="2000" b="1" dirty="0"/>
          </a:p>
        </p:txBody>
      </p:sp>
      <p:sp>
        <p:nvSpPr>
          <p:cNvPr id="93" name="Freeform 92"/>
          <p:cNvSpPr/>
          <p:nvPr/>
        </p:nvSpPr>
        <p:spPr>
          <a:xfrm>
            <a:off x="905277" y="1343106"/>
            <a:ext cx="804672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0" name="Rectangle 79"/>
          <p:cNvSpPr/>
          <p:nvPr/>
        </p:nvSpPr>
        <p:spPr>
          <a:xfrm>
            <a:off x="1810956" y="1267303"/>
            <a:ext cx="49725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NX2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81" name="Freeform 80"/>
          <p:cNvSpPr/>
          <p:nvPr/>
        </p:nvSpPr>
        <p:spPr>
          <a:xfrm>
            <a:off x="1632556" y="1447800"/>
            <a:ext cx="804672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2" name="Rectangle 81"/>
          <p:cNvSpPr/>
          <p:nvPr/>
        </p:nvSpPr>
        <p:spPr>
          <a:xfrm>
            <a:off x="2540615" y="1235683"/>
            <a:ext cx="49725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NX3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83" name="Freeform 82"/>
          <p:cNvSpPr/>
          <p:nvPr/>
        </p:nvSpPr>
        <p:spPr>
          <a:xfrm>
            <a:off x="2343897" y="1396382"/>
            <a:ext cx="804672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pic>
        <p:nvPicPr>
          <p:cNvPr id="97" name="Picture 2"/>
          <p:cNvPicPr>
            <a:picLocks noChangeAspect="1" noChangeArrowheads="1"/>
          </p:cNvPicPr>
          <p:nvPr/>
        </p:nvPicPr>
        <p:blipFill>
          <a:blip r:embed="rId2" cstate="print">
            <a:lum bright="-10000"/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85352" y="2656937"/>
            <a:ext cx="3048000" cy="1828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" name="Group 97"/>
          <p:cNvGrpSpPr/>
          <p:nvPr/>
        </p:nvGrpSpPr>
        <p:grpSpPr>
          <a:xfrm>
            <a:off x="3276600" y="2590800"/>
            <a:ext cx="1528938" cy="1687687"/>
            <a:chOff x="7832378" y="2337005"/>
            <a:chExt cx="1528938" cy="1687687"/>
          </a:xfrm>
        </p:grpSpPr>
        <p:sp>
          <p:nvSpPr>
            <p:cNvPr id="100" name="Rectangle 99"/>
            <p:cNvSpPr/>
            <p:nvPr/>
          </p:nvSpPr>
          <p:spPr>
            <a:xfrm>
              <a:off x="7876461" y="2641805"/>
              <a:ext cx="101502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fil-PH" sz="1100" dirty="0" smtClean="0"/>
                <a:t>OsNX1 (1,285</a:t>
              </a:r>
              <a:r>
                <a:rPr lang="fil-PH" sz="1200" dirty="0" smtClean="0"/>
                <a:t>)</a:t>
              </a:r>
              <a:endParaRPr lang="fil-PH" sz="1200" dirty="0">
                <a:solidFill>
                  <a:srgbClr val="000000"/>
                </a:solidFill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7832378" y="3175205"/>
              <a:ext cx="118850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b"/>
              <a:r>
                <a:rPr lang="fil-PH" sz="1100" dirty="0" smtClean="0"/>
                <a:t>OsNX2 (1,227</a:t>
              </a:r>
              <a:r>
                <a:rPr lang="fil-PH" sz="1200" dirty="0" smtClean="0"/>
                <a:t>)</a:t>
              </a:r>
              <a:endParaRPr lang="fil-PH" sz="1200" dirty="0">
                <a:solidFill>
                  <a:srgbClr val="000000"/>
                </a:solidFill>
              </a:endParaRPr>
            </a:p>
          </p:txBody>
        </p:sp>
        <p:sp>
          <p:nvSpPr>
            <p:cNvPr id="102" name="Rectangle 101"/>
            <p:cNvSpPr/>
            <p:nvPr/>
          </p:nvSpPr>
          <p:spPr>
            <a:xfrm>
              <a:off x="7889130" y="3747693"/>
              <a:ext cx="101502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fil-PH" sz="1100" dirty="0" smtClean="0"/>
                <a:t>OsNX3 (1,339</a:t>
              </a:r>
              <a:r>
                <a:rPr lang="fil-PH" sz="1200" dirty="0" smtClean="0"/>
                <a:t>)</a:t>
              </a:r>
              <a:endParaRPr lang="fil-PH" sz="1200" dirty="0">
                <a:solidFill>
                  <a:srgbClr val="000000"/>
                </a:solidFill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7908578" y="2337005"/>
              <a:ext cx="14527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l-PH" sz="1100" b="1" dirty="0" smtClean="0"/>
                <a:t>Primer set (bp)</a:t>
              </a:r>
              <a:endParaRPr lang="fil-PH" sz="1100" b="1" dirty="0"/>
            </a:p>
          </p:txBody>
        </p:sp>
      </p:grpSp>
      <p:sp>
        <p:nvSpPr>
          <p:cNvPr id="90" name="Rectangle 89"/>
          <p:cNvSpPr/>
          <p:nvPr/>
        </p:nvSpPr>
        <p:spPr>
          <a:xfrm rot="10800000">
            <a:off x="4491473" y="1092198"/>
            <a:ext cx="3336445" cy="1016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grpSp>
        <p:nvGrpSpPr>
          <p:cNvPr id="94" name="Group 4"/>
          <p:cNvGrpSpPr/>
          <p:nvPr/>
        </p:nvGrpSpPr>
        <p:grpSpPr>
          <a:xfrm rot="10800000">
            <a:off x="4736801" y="990598"/>
            <a:ext cx="2862145" cy="304800"/>
            <a:chOff x="321528" y="990598"/>
            <a:chExt cx="2862145" cy="304800"/>
          </a:xfrm>
        </p:grpSpPr>
        <p:sp>
          <p:nvSpPr>
            <p:cNvPr id="95" name="Rectangle 94"/>
            <p:cNvSpPr/>
            <p:nvPr/>
          </p:nvSpPr>
          <p:spPr>
            <a:xfrm rot="10800000">
              <a:off x="321528" y="990598"/>
              <a:ext cx="163551" cy="304800"/>
            </a:xfrm>
            <a:prstGeom prst="rect">
              <a:avLst/>
            </a:prstGeom>
            <a:solidFill>
              <a:schemeClr val="tx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l-PH"/>
            </a:p>
          </p:txBody>
        </p:sp>
        <p:sp>
          <p:nvSpPr>
            <p:cNvPr id="96" name="Rectangle 95"/>
            <p:cNvSpPr/>
            <p:nvPr/>
          </p:nvSpPr>
          <p:spPr>
            <a:xfrm rot="10800000">
              <a:off x="730405" y="990598"/>
              <a:ext cx="163551" cy="304800"/>
            </a:xfrm>
            <a:prstGeom prst="rect">
              <a:avLst/>
            </a:prstGeom>
            <a:solidFill>
              <a:schemeClr val="tx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l-PH"/>
            </a:p>
          </p:txBody>
        </p:sp>
        <p:sp>
          <p:nvSpPr>
            <p:cNvPr id="98" name="Rectangle 97"/>
            <p:cNvSpPr/>
            <p:nvPr/>
          </p:nvSpPr>
          <p:spPr>
            <a:xfrm rot="10800000">
              <a:off x="2447693" y="990598"/>
              <a:ext cx="735980" cy="304800"/>
            </a:xfrm>
            <a:prstGeom prst="rect">
              <a:avLst/>
            </a:prstGeom>
            <a:solidFill>
              <a:schemeClr val="tx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il-PH"/>
            </a:p>
          </p:txBody>
        </p:sp>
      </p:grpSp>
      <p:grpSp>
        <p:nvGrpSpPr>
          <p:cNvPr id="104" name="Group 308"/>
          <p:cNvGrpSpPr/>
          <p:nvPr/>
        </p:nvGrpSpPr>
        <p:grpSpPr>
          <a:xfrm>
            <a:off x="5114685" y="225564"/>
            <a:ext cx="1701264" cy="400110"/>
            <a:chOff x="694574" y="365225"/>
            <a:chExt cx="1701264" cy="400110"/>
          </a:xfrm>
        </p:grpSpPr>
        <p:sp>
          <p:nvSpPr>
            <p:cNvPr id="105" name="TextBox 104"/>
            <p:cNvSpPr txBox="1"/>
            <p:nvPr/>
          </p:nvSpPr>
          <p:spPr>
            <a:xfrm>
              <a:off x="1105653" y="409115"/>
              <a:ext cx="12901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l-PH" sz="1600" b="1" i="1" dirty="0" smtClean="0"/>
                <a:t>OsHKT1;4</a:t>
              </a:r>
              <a:endParaRPr lang="fil-PH" sz="1600" b="1" i="1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94574" y="365225"/>
              <a:ext cx="4892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2000" b="1" dirty="0" smtClean="0"/>
                <a:t>(B)</a:t>
              </a:r>
              <a:endParaRPr lang="fil-PH" sz="2000" b="1" dirty="0"/>
            </a:p>
          </p:txBody>
        </p:sp>
      </p:grpSp>
      <p:grpSp>
        <p:nvGrpSpPr>
          <p:cNvPr id="107" name="Group 196"/>
          <p:cNvGrpSpPr/>
          <p:nvPr/>
        </p:nvGrpSpPr>
        <p:grpSpPr>
          <a:xfrm>
            <a:off x="4824457" y="1387494"/>
            <a:ext cx="612269" cy="97081"/>
            <a:chOff x="2806437" y="1934154"/>
            <a:chExt cx="612269" cy="97081"/>
          </a:xfrm>
        </p:grpSpPr>
        <p:cxnSp>
          <p:nvCxnSpPr>
            <p:cNvPr id="108" name="Straight Connector 107"/>
            <p:cNvCxnSpPr/>
            <p:nvPr/>
          </p:nvCxnSpPr>
          <p:spPr>
            <a:xfrm>
              <a:off x="2816558" y="2031235"/>
              <a:ext cx="6021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2806437" y="1934154"/>
              <a:ext cx="0" cy="970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3418706" y="1934154"/>
              <a:ext cx="0" cy="970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111" name="Group 321"/>
          <p:cNvGrpSpPr/>
          <p:nvPr/>
        </p:nvGrpSpPr>
        <p:grpSpPr>
          <a:xfrm>
            <a:off x="4956722" y="817768"/>
            <a:ext cx="228600" cy="152409"/>
            <a:chOff x="838200" y="2286000"/>
            <a:chExt cx="228600" cy="152409"/>
          </a:xfrm>
        </p:grpSpPr>
        <p:cxnSp>
          <p:nvCxnSpPr>
            <p:cNvPr id="112" name="Straight Connector 111"/>
            <p:cNvCxnSpPr/>
            <p:nvPr/>
          </p:nvCxnSpPr>
          <p:spPr>
            <a:xfrm flipV="1">
              <a:off x="838200" y="2286000"/>
              <a:ext cx="0" cy="1524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3" name="Straight Arrow Connector 112"/>
            <p:cNvCxnSpPr/>
            <p:nvPr/>
          </p:nvCxnSpPr>
          <p:spPr>
            <a:xfrm>
              <a:off x="838200" y="2286000"/>
              <a:ext cx="2286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114" name="TextBox 113"/>
          <p:cNvSpPr txBox="1"/>
          <p:nvPr/>
        </p:nvSpPr>
        <p:spPr>
          <a:xfrm>
            <a:off x="5152097" y="667577"/>
            <a:ext cx="87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art</a:t>
            </a:r>
            <a:endParaRPr lang="fil-PH" sz="1100" dirty="0"/>
          </a:p>
        </p:txBody>
      </p:sp>
      <p:sp>
        <p:nvSpPr>
          <p:cNvPr id="115" name="TextBox 114"/>
          <p:cNvSpPr txBox="1"/>
          <p:nvPr/>
        </p:nvSpPr>
        <p:spPr>
          <a:xfrm>
            <a:off x="7302133" y="667577"/>
            <a:ext cx="7707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op</a:t>
            </a:r>
            <a:endParaRPr lang="fil-PH" sz="1100" dirty="0"/>
          </a:p>
        </p:txBody>
      </p:sp>
      <p:cxnSp>
        <p:nvCxnSpPr>
          <p:cNvPr id="116" name="Straight Connector 115"/>
          <p:cNvCxnSpPr/>
          <p:nvPr/>
        </p:nvCxnSpPr>
        <p:spPr>
          <a:xfrm flipV="1">
            <a:off x="7522751" y="870332"/>
            <a:ext cx="0" cy="1524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117" name="Group 327"/>
          <p:cNvGrpSpPr/>
          <p:nvPr/>
        </p:nvGrpSpPr>
        <p:grpSpPr>
          <a:xfrm>
            <a:off x="7020011" y="1398017"/>
            <a:ext cx="612269" cy="97081"/>
            <a:chOff x="2806437" y="1934154"/>
            <a:chExt cx="612269" cy="97081"/>
          </a:xfrm>
        </p:grpSpPr>
        <p:cxnSp>
          <p:nvCxnSpPr>
            <p:cNvPr id="118" name="Straight Connector 117"/>
            <p:cNvCxnSpPr/>
            <p:nvPr/>
          </p:nvCxnSpPr>
          <p:spPr>
            <a:xfrm>
              <a:off x="2816558" y="2031235"/>
              <a:ext cx="6021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2806437" y="1934154"/>
              <a:ext cx="0" cy="970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>
              <a:off x="3418706" y="1934154"/>
              <a:ext cx="0" cy="970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121" name="TextBox 120"/>
          <p:cNvSpPr txBox="1"/>
          <p:nvPr/>
        </p:nvSpPr>
        <p:spPr>
          <a:xfrm>
            <a:off x="7009379" y="1268508"/>
            <a:ext cx="6542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OsH4</a:t>
            </a:r>
            <a:r>
              <a:rPr lang="en-US" sz="900" dirty="0" smtClean="0"/>
              <a:t> F2</a:t>
            </a:r>
            <a:endParaRPr lang="en-US" sz="900" dirty="0"/>
          </a:p>
        </p:txBody>
      </p:sp>
      <p:sp>
        <p:nvSpPr>
          <p:cNvPr id="122" name="TextBox 121"/>
          <p:cNvSpPr txBox="1"/>
          <p:nvPr/>
        </p:nvSpPr>
        <p:spPr>
          <a:xfrm>
            <a:off x="4803490" y="1264266"/>
            <a:ext cx="6542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"/>
            <a:r>
              <a:rPr lang="en-US" sz="900" dirty="0"/>
              <a:t>OsH4 F1</a:t>
            </a:r>
          </a:p>
        </p:txBody>
      </p:sp>
      <p:pic>
        <p:nvPicPr>
          <p:cNvPr id="123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38415" y="2655518"/>
            <a:ext cx="3438525" cy="12382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5" name="Rectangle 124"/>
          <p:cNvSpPr/>
          <p:nvPr/>
        </p:nvSpPr>
        <p:spPr>
          <a:xfrm>
            <a:off x="7922634" y="2991550"/>
            <a:ext cx="96372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OsH4F1 (345)</a:t>
            </a:r>
            <a:endParaRPr lang="en-US" sz="1100" dirty="0"/>
          </a:p>
        </p:txBody>
      </p:sp>
      <p:sp>
        <p:nvSpPr>
          <p:cNvPr id="126" name="Rectangle 125"/>
          <p:cNvSpPr/>
          <p:nvPr/>
        </p:nvSpPr>
        <p:spPr>
          <a:xfrm>
            <a:off x="7931543" y="3486239"/>
            <a:ext cx="9669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/>
              <a:t>OsH4F2 (188</a:t>
            </a:r>
            <a:r>
              <a:rPr lang="en-US" sz="1200" dirty="0" smtClean="0"/>
              <a:t>)</a:t>
            </a:r>
            <a:endParaRPr lang="en-US" sz="1200" dirty="0"/>
          </a:p>
        </p:txBody>
      </p:sp>
      <p:sp>
        <p:nvSpPr>
          <p:cNvPr id="127" name="TextBox 126"/>
          <p:cNvSpPr txBox="1"/>
          <p:nvPr/>
        </p:nvSpPr>
        <p:spPr>
          <a:xfrm>
            <a:off x="7924800" y="2514600"/>
            <a:ext cx="14527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b="1" dirty="0" smtClean="0"/>
              <a:t>Primer set (bp)</a:t>
            </a:r>
            <a:endParaRPr lang="fil-PH" sz="11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126646" y="4876800"/>
            <a:ext cx="5664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3</a:t>
            </a:r>
            <a:r>
              <a:rPr lang="fil-PH" dirty="0" smtClean="0"/>
              <a:t>: </a:t>
            </a:r>
            <a:r>
              <a:rPr lang="fil-PH" dirty="0"/>
              <a:t>Figure </a:t>
            </a:r>
            <a:r>
              <a:rPr lang="fil-PH" dirty="0" smtClean="0"/>
              <a:t>S2 (A,B)</a:t>
            </a:r>
            <a:r>
              <a:rPr lang="fil-PH" dirty="0" smtClean="0">
                <a:cs typeface="Times New Roman" pitchFamily="18" charset="0"/>
              </a:rPr>
              <a:t> </a:t>
            </a:r>
            <a:endParaRPr lang="fil-PH" dirty="0"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57200" y="5181600"/>
            <a:ext cx="8001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 smtClean="0"/>
              <a:t>Gene structures of the salt tolerant genes with primer binding sites (top) and the gel images of the PCR amplification (bottom).  (A) </a:t>
            </a:r>
            <a:r>
              <a:rPr lang="fil-PH" sz="1600" i="1" dirty="0" smtClean="0"/>
              <a:t>OsNHX1. </a:t>
            </a:r>
            <a:r>
              <a:rPr lang="fil-PH" sz="1600" dirty="0" smtClean="0"/>
              <a:t> (B) </a:t>
            </a:r>
            <a:r>
              <a:rPr lang="fil-PH" sz="1600" i="1" dirty="0" smtClean="0"/>
              <a:t>OsHKT1;4. </a:t>
            </a:r>
            <a:r>
              <a:rPr lang="fil-PH" sz="1600" dirty="0" smtClean="0"/>
              <a:t>Black boxes represent exons.</a:t>
            </a:r>
            <a:endParaRPr lang="fil-PH" sz="1600" dirty="0"/>
          </a:p>
          <a:p>
            <a:endParaRPr lang="fil-PH" sz="1600" dirty="0"/>
          </a:p>
        </p:txBody>
      </p:sp>
      <p:graphicFrame>
        <p:nvGraphicFramePr>
          <p:cNvPr id="69" name="Table 6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11279048"/>
              </p:ext>
            </p:extLst>
          </p:nvPr>
        </p:nvGraphicFramePr>
        <p:xfrm>
          <a:off x="4515875" y="1512729"/>
          <a:ext cx="3447566" cy="990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0516"/>
                <a:gridCol w="271195"/>
                <a:gridCol w="271195"/>
                <a:gridCol w="271195"/>
                <a:gridCol w="271195"/>
                <a:gridCol w="271195"/>
                <a:gridCol w="271195"/>
                <a:gridCol w="271195"/>
                <a:gridCol w="271195"/>
                <a:gridCol w="271195"/>
                <a:gridCol w="271195"/>
                <a:gridCol w="271195"/>
                <a:gridCol w="233905"/>
              </a:tblGrid>
              <a:tr h="990600"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0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DNA Ladder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rhizomat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eichingeri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minu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latifoli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. al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coarcta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O. grandiglum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IR29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FL478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Pokkali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 smtClean="0">
                          <a:effectLst/>
                          <a:latin typeface="+mn-lt"/>
                          <a:cs typeface="Times New Roman" pitchFamily="18" charset="0"/>
                        </a:rPr>
                        <a:t>Nona Bokra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n-lt"/>
                          <a:cs typeface="Times New Roman" pitchFamily="18" charset="0"/>
                        </a:rPr>
                        <a:t>Niponbare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4415680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Table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181241951"/>
              </p:ext>
            </p:extLst>
          </p:nvPr>
        </p:nvGraphicFramePr>
        <p:xfrm>
          <a:off x="4289307" y="1635834"/>
          <a:ext cx="3028946" cy="990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2527"/>
                <a:gridCol w="238265"/>
                <a:gridCol w="238265"/>
                <a:gridCol w="238265"/>
                <a:gridCol w="238265"/>
                <a:gridCol w="238265"/>
                <a:gridCol w="238265"/>
                <a:gridCol w="238265"/>
                <a:gridCol w="238265"/>
                <a:gridCol w="238265"/>
                <a:gridCol w="238265"/>
                <a:gridCol w="238265"/>
                <a:gridCol w="205504"/>
              </a:tblGrid>
              <a:tr h="990600"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0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Ladder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O. rhizomat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eichingeri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minu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latifoli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al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cs typeface="Times New Roman" pitchFamily="18" charset="0"/>
                        </a:rPr>
                        <a:t>O. grandiglum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O. coarcta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IR29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FL478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Pokkali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Nona Bokra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Niponbare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4301776" y="457200"/>
            <a:ext cx="5070824" cy="1250791"/>
            <a:chOff x="361629" y="1998054"/>
            <a:chExt cx="5070824" cy="1250791"/>
          </a:xfrm>
        </p:grpSpPr>
        <p:grpSp>
          <p:nvGrpSpPr>
            <p:cNvPr id="3" name="Group 2"/>
            <p:cNvGrpSpPr/>
            <p:nvPr/>
          </p:nvGrpSpPr>
          <p:grpSpPr>
            <a:xfrm rot="10800000">
              <a:off x="361629" y="2550688"/>
              <a:ext cx="4759569" cy="270164"/>
              <a:chOff x="76200" y="1066797"/>
              <a:chExt cx="7047470" cy="228606"/>
            </a:xfrm>
          </p:grpSpPr>
          <p:sp>
            <p:nvSpPr>
              <p:cNvPr id="38" name="Rectangle 37"/>
              <p:cNvSpPr/>
              <p:nvPr/>
            </p:nvSpPr>
            <p:spPr>
              <a:xfrm rot="10800000">
                <a:off x="76200" y="1136077"/>
                <a:ext cx="7047470" cy="83123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39" name="Rectangle 38"/>
              <p:cNvSpPr/>
              <p:nvPr/>
            </p:nvSpPr>
            <p:spPr>
              <a:xfrm rot="10800000">
                <a:off x="304800" y="1066797"/>
                <a:ext cx="304800" cy="228602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0" name="Rectangle 39"/>
              <p:cNvSpPr/>
              <p:nvPr/>
            </p:nvSpPr>
            <p:spPr>
              <a:xfrm rot="10800000">
                <a:off x="685800" y="1066800"/>
                <a:ext cx="2286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1" name="Rectangle 40"/>
              <p:cNvSpPr/>
              <p:nvPr/>
            </p:nvSpPr>
            <p:spPr>
              <a:xfrm rot="10800000">
                <a:off x="990600" y="1066800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2" name="Rectangle 41"/>
              <p:cNvSpPr/>
              <p:nvPr/>
            </p:nvSpPr>
            <p:spPr>
              <a:xfrm rot="10800000">
                <a:off x="1447800" y="1066801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3" name="Rectangle 42"/>
              <p:cNvSpPr/>
              <p:nvPr/>
            </p:nvSpPr>
            <p:spPr>
              <a:xfrm rot="10800000">
                <a:off x="1676400" y="1066801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4" name="Rectangle 43"/>
              <p:cNvSpPr/>
              <p:nvPr/>
            </p:nvSpPr>
            <p:spPr>
              <a:xfrm rot="10800000">
                <a:off x="1905000" y="1066799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5" name="Rectangle 44"/>
              <p:cNvSpPr/>
              <p:nvPr/>
            </p:nvSpPr>
            <p:spPr>
              <a:xfrm rot="10800000">
                <a:off x="2438400" y="1066800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6" name="Rectangle 45"/>
              <p:cNvSpPr/>
              <p:nvPr/>
            </p:nvSpPr>
            <p:spPr>
              <a:xfrm rot="10800000">
                <a:off x="3200400" y="1066800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7" name="Rectangle 46"/>
              <p:cNvSpPr/>
              <p:nvPr/>
            </p:nvSpPr>
            <p:spPr>
              <a:xfrm rot="10800000">
                <a:off x="3581400" y="1066800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8" name="Rectangle 47"/>
              <p:cNvSpPr/>
              <p:nvPr/>
            </p:nvSpPr>
            <p:spPr>
              <a:xfrm rot="10800000">
                <a:off x="2743200" y="1066800"/>
                <a:ext cx="2286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49" name="Rectangle 48"/>
              <p:cNvSpPr/>
              <p:nvPr/>
            </p:nvSpPr>
            <p:spPr>
              <a:xfrm rot="10800000" flipH="1">
                <a:off x="3688081" y="1066800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0" name="Rectangle 49"/>
              <p:cNvSpPr/>
              <p:nvPr/>
            </p:nvSpPr>
            <p:spPr>
              <a:xfrm rot="10800000">
                <a:off x="3810000" y="1066800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1" name="Rectangle 50"/>
              <p:cNvSpPr/>
              <p:nvPr/>
            </p:nvSpPr>
            <p:spPr>
              <a:xfrm rot="10800000" flipH="1">
                <a:off x="4114800" y="1066799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2" name="Rectangle 51"/>
              <p:cNvSpPr/>
              <p:nvPr/>
            </p:nvSpPr>
            <p:spPr>
              <a:xfrm rot="10800000" flipH="1">
                <a:off x="4221481" y="1066800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3" name="Rectangle 52"/>
              <p:cNvSpPr/>
              <p:nvPr/>
            </p:nvSpPr>
            <p:spPr>
              <a:xfrm rot="10800000" flipH="1">
                <a:off x="4876800" y="1066801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4" name="Rectangle 53"/>
              <p:cNvSpPr/>
              <p:nvPr/>
            </p:nvSpPr>
            <p:spPr>
              <a:xfrm rot="10800000" flipH="1">
                <a:off x="4983481" y="1066802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5" name="Rectangle 54"/>
              <p:cNvSpPr/>
              <p:nvPr/>
            </p:nvSpPr>
            <p:spPr>
              <a:xfrm rot="10800000">
                <a:off x="5334000" y="1066801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6" name="Rectangle 55"/>
              <p:cNvSpPr/>
              <p:nvPr/>
            </p:nvSpPr>
            <p:spPr>
              <a:xfrm rot="10800000">
                <a:off x="5486400" y="1066801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7" name="Rectangle 56"/>
              <p:cNvSpPr/>
              <p:nvPr/>
            </p:nvSpPr>
            <p:spPr>
              <a:xfrm rot="10800000">
                <a:off x="6019800" y="1066801"/>
                <a:ext cx="152400" cy="228600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8" name="Rectangle 57"/>
              <p:cNvSpPr/>
              <p:nvPr/>
            </p:nvSpPr>
            <p:spPr>
              <a:xfrm rot="10800000">
                <a:off x="6248400" y="1066801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59" name="Rectangle 58"/>
              <p:cNvSpPr/>
              <p:nvPr/>
            </p:nvSpPr>
            <p:spPr>
              <a:xfrm rot="10800000">
                <a:off x="6400800" y="1066801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60" name="Rectangle 59"/>
              <p:cNvSpPr/>
              <p:nvPr/>
            </p:nvSpPr>
            <p:spPr>
              <a:xfrm rot="10800000" flipH="1">
                <a:off x="6507481" y="1066801"/>
                <a:ext cx="45719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  <p:sp>
            <p:nvSpPr>
              <p:cNvPr id="61" name="Rectangle 60"/>
              <p:cNvSpPr/>
              <p:nvPr/>
            </p:nvSpPr>
            <p:spPr>
              <a:xfrm rot="10800000">
                <a:off x="6629400" y="1066801"/>
                <a:ext cx="76200" cy="228601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il-PH"/>
              </a:p>
            </p:txBody>
          </p:sp>
        </p:grpSp>
        <p:cxnSp>
          <p:nvCxnSpPr>
            <p:cNvPr id="4" name="Straight Connector 3"/>
            <p:cNvCxnSpPr/>
            <p:nvPr/>
          </p:nvCxnSpPr>
          <p:spPr>
            <a:xfrm flipV="1">
              <a:off x="510066" y="2817632"/>
              <a:ext cx="246578" cy="25916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" name="Group 4"/>
            <p:cNvGrpSpPr/>
            <p:nvPr/>
          </p:nvGrpSpPr>
          <p:grpSpPr>
            <a:xfrm>
              <a:off x="663478" y="2398279"/>
              <a:ext cx="228600" cy="152409"/>
              <a:chOff x="838200" y="2286000"/>
              <a:chExt cx="228600" cy="152409"/>
            </a:xfrm>
          </p:grpSpPr>
          <p:cxnSp>
            <p:nvCxnSpPr>
              <p:cNvPr id="36" name="Straight Connector 35"/>
              <p:cNvCxnSpPr/>
              <p:nvPr/>
            </p:nvCxnSpPr>
            <p:spPr>
              <a:xfrm flipV="1">
                <a:off x="838200" y="2286000"/>
                <a:ext cx="0" cy="15240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/>
              <p:cNvCxnSpPr/>
              <p:nvPr/>
            </p:nvCxnSpPr>
            <p:spPr>
              <a:xfrm>
                <a:off x="838200" y="2286000"/>
                <a:ext cx="2286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/>
            <p:cNvSpPr txBox="1"/>
            <p:nvPr/>
          </p:nvSpPr>
          <p:spPr>
            <a:xfrm>
              <a:off x="904931" y="2245496"/>
              <a:ext cx="8772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l-PH" sz="1100" dirty="0" smtClean="0"/>
                <a:t>Start</a:t>
              </a:r>
              <a:endParaRPr lang="fil-PH" sz="11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661713" y="2225344"/>
              <a:ext cx="770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l-PH" sz="1100" dirty="0" smtClean="0"/>
                <a:t>Stop</a:t>
              </a:r>
              <a:endParaRPr lang="fil-PH" sz="1100" dirty="0"/>
            </a:p>
          </p:txBody>
        </p:sp>
        <p:cxnSp>
          <p:nvCxnSpPr>
            <p:cNvPr id="8" name="Straight Connector 7"/>
            <p:cNvCxnSpPr/>
            <p:nvPr/>
          </p:nvCxnSpPr>
          <p:spPr>
            <a:xfrm flipV="1">
              <a:off x="4863886" y="2415945"/>
              <a:ext cx="0" cy="1524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grpSp>
          <p:nvGrpSpPr>
            <p:cNvPr id="9" name="Group 8"/>
            <p:cNvGrpSpPr/>
            <p:nvPr/>
          </p:nvGrpSpPr>
          <p:grpSpPr>
            <a:xfrm>
              <a:off x="517959" y="3111962"/>
              <a:ext cx="612269" cy="97081"/>
              <a:chOff x="2806437" y="1934154"/>
              <a:chExt cx="612269" cy="97081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>
                <a:off x="2816558" y="2031235"/>
                <a:ext cx="6021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>
                <a:off x="2806437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3418706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sp>
          <p:nvSpPr>
            <p:cNvPr id="10" name="Rectangle 9"/>
            <p:cNvSpPr/>
            <p:nvPr/>
          </p:nvSpPr>
          <p:spPr>
            <a:xfrm>
              <a:off x="530394" y="2962822"/>
              <a:ext cx="67588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 fontAlgn="b"/>
              <a:r>
                <a:rPr lang="en-US" sz="900" dirty="0"/>
                <a:t>SOS1F1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 flipH="1" flipV="1">
              <a:off x="798566" y="2790191"/>
              <a:ext cx="336722" cy="2866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2" name="Group 11"/>
            <p:cNvGrpSpPr/>
            <p:nvPr/>
          </p:nvGrpSpPr>
          <p:grpSpPr>
            <a:xfrm rot="10800000">
              <a:off x="523019" y="1998054"/>
              <a:ext cx="612269" cy="110969"/>
              <a:chOff x="2806437" y="1934154"/>
              <a:chExt cx="612269" cy="97081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>
                <a:off x="2816558" y="2031235"/>
                <a:ext cx="6021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2806437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>
                <a:off x="3418706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cxnSp>
          <p:nvCxnSpPr>
            <p:cNvPr id="13" name="Straight Connector 12"/>
            <p:cNvCxnSpPr>
              <a:stCxn id="15" idx="1"/>
            </p:cNvCxnSpPr>
            <p:nvPr/>
          </p:nvCxnSpPr>
          <p:spPr>
            <a:xfrm>
              <a:off x="517958" y="2114691"/>
              <a:ext cx="238686" cy="44604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927020" y="2122386"/>
              <a:ext cx="208268" cy="41361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Rectangle 14"/>
            <p:cNvSpPr/>
            <p:nvPr/>
          </p:nvSpPr>
          <p:spPr>
            <a:xfrm>
              <a:off x="517958" y="1999275"/>
              <a:ext cx="688323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sz="900" dirty="0"/>
                <a:t>SOS1 F 2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276142" y="3018013"/>
              <a:ext cx="675888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 fontAlgn="b"/>
              <a:r>
                <a:rPr lang="en-US" sz="900" dirty="0"/>
                <a:t>SOS1F 3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762339" y="2817632"/>
              <a:ext cx="581223" cy="28753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1088735" y="2798395"/>
              <a:ext cx="655687" cy="2783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9" name="Group 18"/>
            <p:cNvGrpSpPr/>
            <p:nvPr/>
          </p:nvGrpSpPr>
          <p:grpSpPr>
            <a:xfrm>
              <a:off x="1326161" y="3130848"/>
              <a:ext cx="612269" cy="97081"/>
              <a:chOff x="2806437" y="1934154"/>
              <a:chExt cx="612269" cy="97081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>
                <a:off x="2816558" y="2031235"/>
                <a:ext cx="6021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2806437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3418706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oup 19"/>
            <p:cNvGrpSpPr/>
            <p:nvPr/>
          </p:nvGrpSpPr>
          <p:grpSpPr>
            <a:xfrm>
              <a:off x="2362818" y="3092583"/>
              <a:ext cx="612269" cy="97081"/>
              <a:chOff x="2806437" y="1934154"/>
              <a:chExt cx="612269" cy="97081"/>
            </a:xfrm>
          </p:grpSpPr>
          <p:cxnSp>
            <p:nvCxnSpPr>
              <p:cNvPr id="24" name="Straight Connector 23"/>
              <p:cNvCxnSpPr/>
              <p:nvPr/>
            </p:nvCxnSpPr>
            <p:spPr>
              <a:xfrm>
                <a:off x="2816558" y="2031235"/>
                <a:ext cx="6021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2806437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3418706" y="1934154"/>
                <a:ext cx="0" cy="9708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cxnSp>
          <p:nvCxnSpPr>
            <p:cNvPr id="21" name="Straight Connector 20"/>
            <p:cNvCxnSpPr/>
            <p:nvPr/>
          </p:nvCxnSpPr>
          <p:spPr>
            <a:xfrm flipV="1">
              <a:off x="2362818" y="2848831"/>
              <a:ext cx="158848" cy="22513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2734280" y="2822982"/>
              <a:ext cx="225500" cy="2371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Rectangle 22"/>
            <p:cNvSpPr/>
            <p:nvPr/>
          </p:nvSpPr>
          <p:spPr>
            <a:xfrm>
              <a:off x="2401816" y="2937059"/>
              <a:ext cx="56137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fontAlgn="b"/>
              <a:r>
                <a:rPr lang="en-US" sz="900" dirty="0"/>
                <a:t>SOS1F 4</a:t>
              </a:r>
            </a:p>
          </p:txBody>
        </p:sp>
      </p:grpSp>
      <p:pic>
        <p:nvPicPr>
          <p:cNvPr id="62" name="Picture 1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301776" y="2626434"/>
            <a:ext cx="3038475" cy="3143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Rectangle 63"/>
          <p:cNvSpPr/>
          <p:nvPr/>
        </p:nvSpPr>
        <p:spPr>
          <a:xfrm>
            <a:off x="7333919" y="2940564"/>
            <a:ext cx="13671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100" dirty="0" smtClean="0">
                <a:solidFill>
                  <a:prstClr val="black"/>
                </a:solidFill>
              </a:rPr>
              <a:t>SOS1F1(170</a:t>
            </a:r>
            <a:r>
              <a:rPr lang="en-US" sz="1200" dirty="0" smtClean="0">
                <a:solidFill>
                  <a:prstClr val="black"/>
                </a:solidFill>
              </a:rPr>
              <a:t>)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7325673" y="3617032"/>
            <a:ext cx="13671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100" dirty="0" smtClean="0">
                <a:solidFill>
                  <a:prstClr val="black"/>
                </a:solidFill>
              </a:rPr>
              <a:t>SOS1F2(400</a:t>
            </a:r>
            <a:r>
              <a:rPr lang="en-US" sz="1200" dirty="0" smtClean="0">
                <a:solidFill>
                  <a:prstClr val="black"/>
                </a:solidFill>
              </a:rPr>
              <a:t>)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7325673" y="4302356"/>
            <a:ext cx="13671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100" dirty="0" smtClean="0">
                <a:solidFill>
                  <a:prstClr val="black"/>
                </a:solidFill>
              </a:rPr>
              <a:t>SOS1F3(630</a:t>
            </a:r>
            <a:r>
              <a:rPr lang="en-US" sz="1200" dirty="0" smtClean="0">
                <a:solidFill>
                  <a:prstClr val="black"/>
                </a:solidFill>
              </a:rPr>
              <a:t>)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7344769" y="5246299"/>
            <a:ext cx="13671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100" dirty="0" smtClean="0">
                <a:solidFill>
                  <a:prstClr val="black"/>
                </a:solidFill>
              </a:rPr>
              <a:t>SOS1F4(318</a:t>
            </a:r>
            <a:r>
              <a:rPr lang="en-US" sz="1200" dirty="0" smtClean="0">
                <a:solidFill>
                  <a:prstClr val="black"/>
                </a:solidFill>
              </a:rPr>
              <a:t>)</a:t>
            </a:r>
            <a:endParaRPr lang="en-US" sz="1200" dirty="0">
              <a:solidFill>
                <a:prstClr val="black"/>
              </a:solidFill>
            </a:endParaRPr>
          </a:p>
        </p:txBody>
      </p:sp>
      <p:grpSp>
        <p:nvGrpSpPr>
          <p:cNvPr id="68" name="Group 67"/>
          <p:cNvGrpSpPr/>
          <p:nvPr/>
        </p:nvGrpSpPr>
        <p:grpSpPr>
          <a:xfrm>
            <a:off x="4450728" y="26129"/>
            <a:ext cx="1701264" cy="400110"/>
            <a:chOff x="694574" y="365225"/>
            <a:chExt cx="1701264" cy="400110"/>
          </a:xfrm>
        </p:grpSpPr>
        <p:sp>
          <p:nvSpPr>
            <p:cNvPr id="69" name="TextBox 68"/>
            <p:cNvSpPr txBox="1"/>
            <p:nvPr/>
          </p:nvSpPr>
          <p:spPr>
            <a:xfrm>
              <a:off x="1105653" y="409115"/>
              <a:ext cx="12901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l-PH" sz="1600" b="1" i="1" dirty="0" smtClean="0"/>
                <a:t>OsSOS1</a:t>
              </a:r>
              <a:endParaRPr lang="fil-PH" sz="1600" b="1" i="1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694574" y="365225"/>
              <a:ext cx="5068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2000" b="1" dirty="0" smtClean="0"/>
                <a:t>(D)</a:t>
              </a:r>
              <a:endParaRPr lang="fil-PH" sz="2000" b="1" dirty="0"/>
            </a:p>
          </p:txBody>
        </p:sp>
      </p:grpSp>
      <p:graphicFrame>
        <p:nvGraphicFramePr>
          <p:cNvPr id="71" name="Table 7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593934505"/>
              </p:ext>
            </p:extLst>
          </p:nvPr>
        </p:nvGraphicFramePr>
        <p:xfrm>
          <a:off x="109834" y="1600200"/>
          <a:ext cx="2933703" cy="990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6158"/>
                <a:gridCol w="230773"/>
                <a:gridCol w="230773"/>
                <a:gridCol w="230773"/>
                <a:gridCol w="230773"/>
                <a:gridCol w="230773"/>
                <a:gridCol w="230773"/>
                <a:gridCol w="230773"/>
                <a:gridCol w="230773"/>
                <a:gridCol w="230773"/>
                <a:gridCol w="230773"/>
                <a:gridCol w="230773"/>
                <a:gridCol w="199042"/>
              </a:tblGrid>
              <a:tr h="990600"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0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DNA</a:t>
                      </a:r>
                      <a:r>
                        <a:rPr lang="fil-PH" sz="1000" b="1" i="0" u="none" strike="noStrike" baseline="0" dirty="0" smtClean="0">
                          <a:effectLst/>
                          <a:latin typeface="+mj-lt"/>
                          <a:cs typeface="Times New Roman" pitchFamily="18" charset="0"/>
                        </a:rPr>
                        <a:t> </a:t>
                      </a:r>
                      <a:r>
                        <a:rPr lang="fil-PH" sz="1000" b="1" i="0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Ladder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O. rhizomat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eichingeri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minu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latifoli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O</a:t>
                      </a:r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. al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O. coarctata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i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O. grandiglumis</a:t>
                      </a:r>
                      <a:endParaRPr lang="fil-PH" sz="1000" b="1" i="1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IR29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FL478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Pokkali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 smtClean="0">
                          <a:effectLst/>
                          <a:latin typeface="+mj-lt"/>
                          <a:cs typeface="Times New Roman" pitchFamily="18" charset="0"/>
                        </a:rPr>
                        <a:t>Nona Bokra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l-PH" sz="1000" b="1" u="none" strike="noStrike" dirty="0">
                          <a:effectLst/>
                          <a:latin typeface="+mj-lt"/>
                          <a:cs typeface="Times New Roman" pitchFamily="18" charset="0"/>
                        </a:rPr>
                        <a:t>Niponbare</a:t>
                      </a:r>
                      <a:endParaRPr lang="fil-PH" sz="10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  <a:cs typeface="Times New Roman" pitchFamily="18" charset="0"/>
                      </a:endParaRPr>
                    </a:p>
                  </a:txBody>
                  <a:tcPr marL="9525" marR="9525" marT="9525" marB="0" vert="vert270" anchor="b"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72" name="Rectangle 71"/>
          <p:cNvSpPr/>
          <p:nvPr/>
        </p:nvSpPr>
        <p:spPr>
          <a:xfrm>
            <a:off x="2998340" y="4298264"/>
            <a:ext cx="119266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4 (1,311)</a:t>
            </a:r>
            <a:endParaRPr lang="fil-PH" sz="1100" dirty="0"/>
          </a:p>
        </p:txBody>
      </p:sp>
      <p:sp>
        <p:nvSpPr>
          <p:cNvPr id="73" name="Rectangle 72"/>
          <p:cNvSpPr/>
          <p:nvPr/>
        </p:nvSpPr>
        <p:spPr>
          <a:xfrm>
            <a:off x="2998340" y="3764864"/>
            <a:ext cx="114626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3 (1,307)</a:t>
            </a:r>
            <a:endParaRPr lang="fil-PH" sz="1100" dirty="0"/>
          </a:p>
        </p:txBody>
      </p:sp>
      <p:sp>
        <p:nvSpPr>
          <p:cNvPr id="74" name="Rectangle 73"/>
          <p:cNvSpPr/>
          <p:nvPr/>
        </p:nvSpPr>
        <p:spPr>
          <a:xfrm>
            <a:off x="2998340" y="3231464"/>
            <a:ext cx="117062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2 (1,313)</a:t>
            </a:r>
            <a:endParaRPr lang="fil-PH" sz="1100" dirty="0"/>
          </a:p>
        </p:txBody>
      </p:sp>
      <p:sp>
        <p:nvSpPr>
          <p:cNvPr id="75" name="Rectangle 74"/>
          <p:cNvSpPr/>
          <p:nvPr/>
        </p:nvSpPr>
        <p:spPr>
          <a:xfrm>
            <a:off x="2998340" y="2698064"/>
            <a:ext cx="114626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1 (1,050)</a:t>
            </a:r>
            <a:endParaRPr lang="fil-PH" sz="1100" dirty="0"/>
          </a:p>
        </p:txBody>
      </p:sp>
      <p:sp>
        <p:nvSpPr>
          <p:cNvPr id="76" name="TextBox 75"/>
          <p:cNvSpPr txBox="1"/>
          <p:nvPr/>
        </p:nvSpPr>
        <p:spPr>
          <a:xfrm>
            <a:off x="614815" y="82130"/>
            <a:ext cx="12901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600" b="1" i="1" dirty="0" smtClean="0"/>
              <a:t>OsHKT1;5</a:t>
            </a:r>
            <a:endParaRPr lang="fil-PH" sz="1600" b="1" i="1" dirty="0"/>
          </a:p>
        </p:txBody>
      </p:sp>
      <p:sp>
        <p:nvSpPr>
          <p:cNvPr id="77" name="Rectangle 76"/>
          <p:cNvSpPr/>
          <p:nvPr/>
        </p:nvSpPr>
        <p:spPr>
          <a:xfrm rot="10800000">
            <a:off x="76201" y="1097189"/>
            <a:ext cx="3657600" cy="762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78" name="Rectangle 77"/>
          <p:cNvSpPr/>
          <p:nvPr/>
        </p:nvSpPr>
        <p:spPr>
          <a:xfrm rot="10800000">
            <a:off x="3082603" y="1020989"/>
            <a:ext cx="152400" cy="228600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79" name="Rectangle 78"/>
          <p:cNvSpPr/>
          <p:nvPr/>
        </p:nvSpPr>
        <p:spPr>
          <a:xfrm rot="10800000">
            <a:off x="2543684" y="1011464"/>
            <a:ext cx="152400" cy="228600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sp>
        <p:nvSpPr>
          <p:cNvPr id="80" name="Rectangle 79"/>
          <p:cNvSpPr/>
          <p:nvPr/>
        </p:nvSpPr>
        <p:spPr>
          <a:xfrm rot="10800000">
            <a:off x="644810" y="1020989"/>
            <a:ext cx="755875" cy="228600"/>
          </a:xfrm>
          <a:prstGeom prst="rect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l-PH"/>
          </a:p>
        </p:txBody>
      </p:sp>
      <p:grpSp>
        <p:nvGrpSpPr>
          <p:cNvPr id="81" name="Group 13"/>
          <p:cNvGrpSpPr/>
          <p:nvPr/>
        </p:nvGrpSpPr>
        <p:grpSpPr>
          <a:xfrm>
            <a:off x="794147" y="882508"/>
            <a:ext cx="228600" cy="152409"/>
            <a:chOff x="838200" y="2286000"/>
            <a:chExt cx="228600" cy="152409"/>
          </a:xfrm>
        </p:grpSpPr>
        <p:cxnSp>
          <p:nvCxnSpPr>
            <p:cNvPr id="82" name="Straight Connector 81"/>
            <p:cNvCxnSpPr/>
            <p:nvPr/>
          </p:nvCxnSpPr>
          <p:spPr>
            <a:xfrm flipV="1">
              <a:off x="838200" y="2286000"/>
              <a:ext cx="0" cy="15240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/>
            <p:nvPr/>
          </p:nvCxnSpPr>
          <p:spPr>
            <a:xfrm>
              <a:off x="838200" y="2286000"/>
              <a:ext cx="2286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cxnSp>
        <p:nvCxnSpPr>
          <p:cNvPr id="84" name="Straight Connector 83"/>
          <p:cNvCxnSpPr/>
          <p:nvPr/>
        </p:nvCxnSpPr>
        <p:spPr>
          <a:xfrm flipV="1">
            <a:off x="3145806" y="916223"/>
            <a:ext cx="0" cy="1524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989523" y="732327"/>
            <a:ext cx="87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art</a:t>
            </a:r>
            <a:endParaRPr lang="fil-PH" sz="1100" dirty="0"/>
          </a:p>
        </p:txBody>
      </p:sp>
      <p:sp>
        <p:nvSpPr>
          <p:cNvPr id="86" name="TextBox 85"/>
          <p:cNvSpPr txBox="1"/>
          <p:nvPr/>
        </p:nvSpPr>
        <p:spPr>
          <a:xfrm>
            <a:off x="2963061" y="702718"/>
            <a:ext cx="7707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dirty="0" smtClean="0"/>
              <a:t>Stop</a:t>
            </a:r>
            <a:endParaRPr lang="fil-PH" sz="1100" dirty="0"/>
          </a:p>
        </p:txBody>
      </p:sp>
      <p:sp>
        <p:nvSpPr>
          <p:cNvPr id="87" name="TextBox 86"/>
          <p:cNvSpPr txBox="1"/>
          <p:nvPr/>
        </p:nvSpPr>
        <p:spPr>
          <a:xfrm>
            <a:off x="227623" y="51352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l-PH" sz="2000" b="1" dirty="0" smtClean="0"/>
              <a:t>(C)</a:t>
            </a:r>
            <a:endParaRPr lang="fil-PH" sz="2000" b="1" dirty="0"/>
          </a:p>
        </p:txBody>
      </p:sp>
      <p:sp>
        <p:nvSpPr>
          <p:cNvPr id="88" name="Rectangle 87"/>
          <p:cNvSpPr/>
          <p:nvPr/>
        </p:nvSpPr>
        <p:spPr>
          <a:xfrm>
            <a:off x="358362" y="1216968"/>
            <a:ext cx="49244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HT1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89" name="Freeform 88"/>
          <p:cNvSpPr/>
          <p:nvPr/>
        </p:nvSpPr>
        <p:spPr>
          <a:xfrm>
            <a:off x="262129" y="1387099"/>
            <a:ext cx="640080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pic>
        <p:nvPicPr>
          <p:cNvPr id="9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6201" y="2621864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1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6201" y="3155264"/>
            <a:ext cx="2971800" cy="4779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2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6201" y="3688664"/>
            <a:ext cx="2971800" cy="4578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3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6201" y="4222064"/>
            <a:ext cx="2971800" cy="4375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4" name="Rectangle 93"/>
          <p:cNvSpPr/>
          <p:nvPr/>
        </p:nvSpPr>
        <p:spPr>
          <a:xfrm>
            <a:off x="1658778" y="1111081"/>
            <a:ext cx="49244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HT2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95" name="Freeform 94"/>
          <p:cNvSpPr/>
          <p:nvPr/>
        </p:nvSpPr>
        <p:spPr>
          <a:xfrm>
            <a:off x="1557529" y="1305337"/>
            <a:ext cx="731520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6" name="Rectangle 95"/>
          <p:cNvSpPr/>
          <p:nvPr/>
        </p:nvSpPr>
        <p:spPr>
          <a:xfrm>
            <a:off x="2326958" y="1189536"/>
            <a:ext cx="49244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HT3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97" name="Freeform 96"/>
          <p:cNvSpPr/>
          <p:nvPr/>
        </p:nvSpPr>
        <p:spPr>
          <a:xfrm>
            <a:off x="2209801" y="1402080"/>
            <a:ext cx="731520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8" name="Rectangle 97"/>
          <p:cNvSpPr/>
          <p:nvPr/>
        </p:nvSpPr>
        <p:spPr>
          <a:xfrm>
            <a:off x="2998452" y="1197516"/>
            <a:ext cx="49244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fil-PH" sz="900" dirty="0" smtClean="0"/>
              <a:t>OsHT4</a:t>
            </a:r>
            <a:endParaRPr lang="fil-PH" sz="900" dirty="0">
              <a:solidFill>
                <a:srgbClr val="000000"/>
              </a:solidFill>
            </a:endParaRPr>
          </a:p>
        </p:txBody>
      </p:sp>
      <p:sp>
        <p:nvSpPr>
          <p:cNvPr id="99" name="Freeform 98"/>
          <p:cNvSpPr/>
          <p:nvPr/>
        </p:nvSpPr>
        <p:spPr>
          <a:xfrm>
            <a:off x="2832221" y="1371732"/>
            <a:ext cx="731520" cy="36576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pic>
        <p:nvPicPr>
          <p:cNvPr id="100" name="Picture 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76201" y="4724400"/>
            <a:ext cx="2971800" cy="504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1" name="Rectangle 100"/>
          <p:cNvSpPr/>
          <p:nvPr/>
        </p:nvSpPr>
        <p:spPr>
          <a:xfrm>
            <a:off x="3005435" y="4949646"/>
            <a:ext cx="119266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5 (215)</a:t>
            </a:r>
            <a:endParaRPr lang="fil-PH" sz="1100" dirty="0"/>
          </a:p>
        </p:txBody>
      </p:sp>
      <p:sp>
        <p:nvSpPr>
          <p:cNvPr id="102" name="Freeform 101"/>
          <p:cNvSpPr/>
          <p:nvPr/>
        </p:nvSpPr>
        <p:spPr>
          <a:xfrm flipV="1">
            <a:off x="2782254" y="389616"/>
            <a:ext cx="731447" cy="45719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cxnSp>
        <p:nvCxnSpPr>
          <p:cNvPr id="103" name="Straight Connector 102"/>
          <p:cNvCxnSpPr/>
          <p:nvPr/>
        </p:nvCxnSpPr>
        <p:spPr>
          <a:xfrm>
            <a:off x="2785665" y="475441"/>
            <a:ext cx="311311" cy="65032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flipH="1">
            <a:off x="3208978" y="474743"/>
            <a:ext cx="304723" cy="5938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Rectangle 104"/>
          <p:cNvSpPr/>
          <p:nvPr/>
        </p:nvSpPr>
        <p:spPr>
          <a:xfrm>
            <a:off x="2938938" y="358036"/>
            <a:ext cx="49244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900" dirty="0"/>
              <a:t>OsHT5</a:t>
            </a:r>
          </a:p>
        </p:txBody>
      </p:sp>
      <p:sp>
        <p:nvSpPr>
          <p:cNvPr id="106" name="Rectangle 105"/>
          <p:cNvSpPr/>
          <p:nvPr/>
        </p:nvSpPr>
        <p:spPr>
          <a:xfrm>
            <a:off x="3011139" y="5467430"/>
            <a:ext cx="119266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100" dirty="0" smtClean="0"/>
              <a:t>OsHT6 (321)</a:t>
            </a:r>
            <a:endParaRPr lang="fil-PH" sz="1100" dirty="0"/>
          </a:p>
        </p:txBody>
      </p:sp>
      <p:pic>
        <p:nvPicPr>
          <p:cNvPr id="107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1423" y="5293435"/>
            <a:ext cx="2986578" cy="6095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8" name="Rectangle 107"/>
          <p:cNvSpPr/>
          <p:nvPr/>
        </p:nvSpPr>
        <p:spPr>
          <a:xfrm>
            <a:off x="862225" y="1208209"/>
            <a:ext cx="49244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l-PH" sz="900" dirty="0" smtClean="0"/>
              <a:t>OsHT6</a:t>
            </a:r>
            <a:endParaRPr lang="fil-PH" sz="900" dirty="0"/>
          </a:p>
        </p:txBody>
      </p:sp>
      <p:sp>
        <p:nvSpPr>
          <p:cNvPr id="109" name="Freeform 108"/>
          <p:cNvSpPr/>
          <p:nvPr/>
        </p:nvSpPr>
        <p:spPr>
          <a:xfrm>
            <a:off x="863758" y="1338014"/>
            <a:ext cx="464366" cy="45719"/>
          </a:xfrm>
          <a:custGeom>
            <a:avLst/>
            <a:gdLst>
              <a:gd name="connsiteX0" fmla="*/ 0 w 731520"/>
              <a:gd name="connsiteY0" fmla="*/ 0 h 111319"/>
              <a:gd name="connsiteX1" fmla="*/ 0 w 731520"/>
              <a:gd name="connsiteY1" fmla="*/ 111319 h 111319"/>
              <a:gd name="connsiteX2" fmla="*/ 731520 w 731520"/>
              <a:gd name="connsiteY2" fmla="*/ 111319 h 111319"/>
              <a:gd name="connsiteX3" fmla="*/ 731520 w 731520"/>
              <a:gd name="connsiteY3" fmla="*/ 0 h 1113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1520" h="111319">
                <a:moveTo>
                  <a:pt x="0" y="0"/>
                </a:moveTo>
                <a:lnTo>
                  <a:pt x="0" y="111319"/>
                </a:lnTo>
                <a:lnTo>
                  <a:pt x="731520" y="111319"/>
                </a:lnTo>
                <a:lnTo>
                  <a:pt x="731520" y="0"/>
                </a:lnTo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10" name="TextBox 109"/>
          <p:cNvSpPr txBox="1"/>
          <p:nvPr/>
        </p:nvSpPr>
        <p:spPr>
          <a:xfrm>
            <a:off x="3048000" y="2397834"/>
            <a:ext cx="14527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b="1" dirty="0" smtClean="0"/>
              <a:t>Primer set (bp)</a:t>
            </a:r>
            <a:endParaRPr lang="fil-PH" sz="11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7325673" y="2588854"/>
            <a:ext cx="14527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sz="1100" b="1" dirty="0" smtClean="0"/>
              <a:t>Primer set (bp)</a:t>
            </a:r>
            <a:endParaRPr lang="fil-PH" sz="1100" b="1" dirty="0"/>
          </a:p>
        </p:txBody>
      </p:sp>
      <p:sp>
        <p:nvSpPr>
          <p:cNvPr id="117" name="TextBox 116"/>
          <p:cNvSpPr txBox="1"/>
          <p:nvPr/>
        </p:nvSpPr>
        <p:spPr>
          <a:xfrm>
            <a:off x="0" y="5915110"/>
            <a:ext cx="5664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3</a:t>
            </a:r>
            <a:r>
              <a:rPr lang="fil-PH" dirty="0" smtClean="0"/>
              <a:t>: </a:t>
            </a:r>
            <a:r>
              <a:rPr lang="fil-PH" dirty="0"/>
              <a:t>Figure </a:t>
            </a:r>
            <a:r>
              <a:rPr lang="fil-PH" dirty="0" smtClean="0"/>
              <a:t>S2 (C,D)</a:t>
            </a:r>
            <a:r>
              <a:rPr lang="fil-PH" dirty="0" smtClean="0">
                <a:cs typeface="Times New Roman" pitchFamily="18" charset="0"/>
              </a:rPr>
              <a:t> </a:t>
            </a:r>
            <a:endParaRPr lang="fil-PH" dirty="0">
              <a:cs typeface="Times New Roman" pitchFamily="18" charset="0"/>
            </a:endParaRPr>
          </a:p>
        </p:txBody>
      </p:sp>
      <p:sp>
        <p:nvSpPr>
          <p:cNvPr id="118" name="Rectangle 117"/>
          <p:cNvSpPr/>
          <p:nvPr/>
        </p:nvSpPr>
        <p:spPr>
          <a:xfrm>
            <a:off x="381000" y="6248400"/>
            <a:ext cx="80010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 smtClean="0"/>
              <a:t>Gene structures of the salt tolerant genes with primer binding sites (top) and the gel images of the PCR amplification (bottom).  (C) </a:t>
            </a:r>
            <a:r>
              <a:rPr lang="fil-PH" sz="1600" i="1" dirty="0" smtClean="0"/>
              <a:t>OsHKT1;5. </a:t>
            </a:r>
            <a:r>
              <a:rPr lang="fil-PH" sz="1600" dirty="0" smtClean="0"/>
              <a:t> (D) </a:t>
            </a:r>
            <a:r>
              <a:rPr lang="fil-PH" sz="1600" i="1" dirty="0" smtClean="0"/>
              <a:t>OsSOS1. </a:t>
            </a:r>
            <a:r>
              <a:rPr lang="fil-PH" sz="1600" dirty="0" smtClean="0"/>
              <a:t>Black boxes represent exons.</a:t>
            </a:r>
            <a:endParaRPr lang="fil-PH" sz="1600" dirty="0"/>
          </a:p>
        </p:txBody>
      </p:sp>
    </p:spTree>
    <p:extLst>
      <p:ext uri="{BB962C8B-B14F-4D97-AF65-F5344CB8AC3E}">
        <p14:creationId xmlns:p14="http://schemas.microsoft.com/office/powerpoint/2010/main" xmlns="" val="685529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07545" y="1219200"/>
            <a:ext cx="5029200" cy="2743200"/>
            <a:chOff x="685800" y="1295400"/>
            <a:chExt cx="5029200" cy="2743200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4049228098"/>
                </p:ext>
              </p:extLst>
            </p:nvPr>
          </p:nvGraphicFramePr>
          <p:xfrm>
            <a:off x="1143000" y="1295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3345408" y="1361699"/>
              <a:ext cx="2584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 smtClean="0">
                  <a:cs typeface="Times New Roman" pitchFamily="18" charset="0"/>
                </a:rPr>
                <a:t>a</a:t>
              </a:r>
              <a:endParaRPr lang="fil-PH" sz="1200" dirty="0"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271929" y="2895599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606354" y="287363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952843" y="287363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16015" y="2873629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962400" y="2865485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661351" y="2873630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27335" y="2862622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14470" y="2854477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62200" y="2849442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57400" y="2862621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676400" y="2854477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il-PH" sz="1200" dirty="0">
                  <a:cs typeface="Times New Roman" pitchFamily="18" charset="0"/>
                </a:rPr>
                <a:t>b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5800" y="1828800"/>
              <a:ext cx="553998" cy="83820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endParaRPr lang="fil-PH" sz="120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fil-PH" sz="1200" b="1" dirty="0">
                  <a:latin typeface="Times New Roman" pitchFamily="18" charset="0"/>
                  <a:cs typeface="Times New Roman" pitchFamily="18" charset="0"/>
                </a:rPr>
                <a:t>Na</a:t>
              </a:r>
              <a:r>
                <a:rPr lang="fil-PH" sz="1200" b="1" baseline="30000" dirty="0" smtClean="0">
                  <a:latin typeface="Times New Roman" pitchFamily="18" charset="0"/>
                  <a:cs typeface="Times New Roman" pitchFamily="18" charset="0"/>
                </a:rPr>
                <a:t>+ </a:t>
              </a:r>
              <a:r>
                <a:rPr lang="fil-PH" sz="1200" b="1" dirty="0" smtClean="0">
                  <a:latin typeface="Times New Roman" pitchFamily="18" charset="0"/>
                  <a:cs typeface="Times New Roman" pitchFamily="18" charset="0"/>
                </a:rPr>
                <a:t>(%)</a:t>
              </a:r>
              <a:endParaRPr lang="fil-PH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381000" y="4572000"/>
            <a:ext cx="828325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/>
              <a:t>Measurement of</a:t>
            </a:r>
            <a:r>
              <a:rPr lang="fil-PH" sz="1600" b="1" dirty="0"/>
              <a:t> </a:t>
            </a:r>
            <a:r>
              <a:rPr lang="fil-PH" sz="1600" dirty="0"/>
              <a:t>Na</a:t>
            </a:r>
            <a:r>
              <a:rPr lang="fil-PH" sz="1600" baseline="30000" dirty="0"/>
              <a:t>+</a:t>
            </a:r>
            <a:r>
              <a:rPr lang="fil-PH" sz="1600" dirty="0"/>
              <a:t> content</a:t>
            </a:r>
            <a:r>
              <a:rPr lang="fil-PH" sz="1600" b="1" dirty="0"/>
              <a:t> </a:t>
            </a:r>
            <a:r>
              <a:rPr lang="fil-PH" sz="1600" dirty="0"/>
              <a:t>per unit area (mm</a:t>
            </a:r>
            <a:r>
              <a:rPr lang="fil-PH" sz="1600" baseline="30000" dirty="0"/>
              <a:t>2</a:t>
            </a:r>
            <a:r>
              <a:rPr lang="fil-PH" sz="1600" dirty="0"/>
              <a:t>) in the leaf exudates of salt tolerant wild species </a:t>
            </a:r>
            <a:r>
              <a:rPr lang="fil-PH" sz="1600" dirty="0" smtClean="0"/>
              <a:t>and </a:t>
            </a:r>
            <a:r>
              <a:rPr lang="fil-PH" sz="1600" dirty="0"/>
              <a:t>checks. Mean value (</a:t>
            </a:r>
            <a:r>
              <a:rPr lang="fil-PH" sz="1600" i="1" dirty="0"/>
              <a:t>n</a:t>
            </a:r>
            <a:r>
              <a:rPr lang="fil-PH" sz="1600" dirty="0"/>
              <a:t>=5). Letters in th error bar follwed by differnt letters are statistically different as analyzed by DMRT (</a:t>
            </a:r>
            <a:r>
              <a:rPr lang="fil-PH" sz="1600" i="1" dirty="0"/>
              <a:t>p</a:t>
            </a:r>
            <a:r>
              <a:rPr lang="fil-PH" sz="1600" dirty="0"/>
              <a:t>&lt;0.05).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2400" y="4267200"/>
            <a:ext cx="407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</a:t>
            </a:r>
            <a:r>
              <a:rPr lang="fil-PH" dirty="0" smtClean="0"/>
              <a:t>4: </a:t>
            </a:r>
            <a:r>
              <a:rPr lang="fil-PH" dirty="0"/>
              <a:t>Figure </a:t>
            </a:r>
            <a:r>
              <a:rPr lang="fil-PH" dirty="0" smtClean="0"/>
              <a:t>S3</a:t>
            </a:r>
            <a:r>
              <a:rPr lang="fil-PH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il-PH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016682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52400"/>
            <a:ext cx="3790950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304800" y="6067251"/>
            <a:ext cx="7239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l-PH" sz="1600" dirty="0" smtClean="0"/>
              <a:t>Transversection </a:t>
            </a:r>
            <a:r>
              <a:rPr lang="fil-PH" sz="1600" dirty="0"/>
              <a:t>of leafs of </a:t>
            </a:r>
            <a:r>
              <a:rPr lang="fil-PH" sz="1600" dirty="0" smtClean="0"/>
              <a:t>different salt </a:t>
            </a:r>
            <a:r>
              <a:rPr lang="fil-PH" sz="1600" dirty="0"/>
              <a:t>tolerant wild </a:t>
            </a:r>
            <a:r>
              <a:rPr lang="fil-PH" sz="1600" dirty="0" smtClean="0"/>
              <a:t>genotypes and check lines. Arrow points salt glands. A: </a:t>
            </a:r>
            <a:r>
              <a:rPr lang="fil-PH" sz="1600" i="1" dirty="0" smtClean="0"/>
              <a:t>O. rhizomatis</a:t>
            </a:r>
            <a:r>
              <a:rPr lang="fil-PH" sz="1600" dirty="0" smtClean="0"/>
              <a:t>, B: </a:t>
            </a:r>
            <a:r>
              <a:rPr lang="fil-PH" sz="1600" i="1" dirty="0" smtClean="0"/>
              <a:t>O. eichingeri</a:t>
            </a:r>
            <a:r>
              <a:rPr lang="fil-PH" sz="1600" dirty="0" smtClean="0"/>
              <a:t>, C: </a:t>
            </a:r>
            <a:r>
              <a:rPr lang="fil-PH" sz="1600" i="1" dirty="0" smtClean="0"/>
              <a:t>O. minuta</a:t>
            </a:r>
            <a:r>
              <a:rPr lang="fil-PH" sz="1600" dirty="0" smtClean="0"/>
              <a:t>, D: </a:t>
            </a:r>
            <a:r>
              <a:rPr lang="fil-PH" sz="1600" i="1" dirty="0" smtClean="0"/>
              <a:t>O. latifolia</a:t>
            </a:r>
            <a:r>
              <a:rPr lang="fil-PH" sz="1600" dirty="0" smtClean="0"/>
              <a:t>, E: </a:t>
            </a:r>
            <a:r>
              <a:rPr lang="fil-PH" sz="1600" i="1" dirty="0" smtClean="0"/>
              <a:t>O.alta</a:t>
            </a:r>
            <a:r>
              <a:rPr lang="fil-PH" sz="1600" dirty="0" smtClean="0"/>
              <a:t>, F: </a:t>
            </a:r>
            <a:r>
              <a:rPr lang="fil-PH" sz="1600" i="1" dirty="0" smtClean="0"/>
              <a:t>O. grandiglumis</a:t>
            </a:r>
            <a:r>
              <a:rPr lang="fil-PH" sz="1600" dirty="0" smtClean="0"/>
              <a:t>, G: </a:t>
            </a:r>
            <a:r>
              <a:rPr lang="fil-PH" sz="1600" i="1" dirty="0" smtClean="0"/>
              <a:t>O. coarctata</a:t>
            </a:r>
          </a:p>
          <a:p>
            <a:endParaRPr lang="fil-PH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152400" y="5638800"/>
            <a:ext cx="4078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l-PH" dirty="0"/>
              <a:t>Additional file 5</a:t>
            </a:r>
            <a:r>
              <a:rPr lang="fil-PH" dirty="0" smtClean="0"/>
              <a:t>: </a:t>
            </a:r>
            <a:r>
              <a:rPr lang="fil-PH" dirty="0"/>
              <a:t>Figure </a:t>
            </a:r>
            <a:r>
              <a:rPr lang="fil-PH" dirty="0" smtClean="0"/>
              <a:t>S4</a:t>
            </a:r>
            <a:r>
              <a:rPr lang="fil-PH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il-PH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54285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93D655ED0060C4AAC022E8E2257A357" ma:contentTypeVersion="7" ma:contentTypeDescription="Create a new document." ma:contentTypeScope="" ma:versionID="0796be3df34c51f6c7617158e464225a">
  <xsd:schema xmlns:xsd="http://www.w3.org/2001/XMLSchema" xmlns:p="http://schemas.microsoft.com/office/2006/metadata/properties" xmlns:ns2="f1ac3016-fbeb-46df-af3f-f1b6e38c419b" targetNamespace="http://schemas.microsoft.com/office/2006/metadata/properties" ma:root="true" ma:fieldsID="d5f39de5fea44875788416896280277c" ns2:_="">
    <xsd:import namespace="f1ac3016-fbeb-46df-af3f-f1b6e38c419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1ac3016-fbeb-46df-af3f-f1b6e38c419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TitleName xmlns="f1ac3016-fbeb-46df-af3f-f1b6e38c419b">Presentation 1.PPTX</TitleName>
    <DocumentId xmlns="f1ac3016-fbeb-46df-af3f-f1b6e38c419b">Presentation 1.PPTX</DocumentId>
    <DocumentType xmlns="f1ac3016-fbeb-46df-af3f-f1b6e38c419b">Presentation</DocumentType>
    <FileFormat xmlns="f1ac3016-fbeb-46df-af3f-f1b6e38c419b">PPTX</FileFormat>
    <Checked_x0020_Out_x0020_To xmlns="f1ac3016-fbeb-46df-af3f-f1b6e38c419b">
      <UserInfo>
        <DisplayName/>
        <AccountId xsi:nil="true"/>
        <AccountType/>
      </UserInfo>
    </Checked_x0020_Out_x0020_To>
    <IsDeleted xmlns="f1ac3016-fbeb-46df-af3f-f1b6e38c419b">false</IsDeleted>
    <StageName xmlns="f1ac3016-fbeb-46df-af3f-f1b6e38c419b" xsi:nil="true"/>
  </documentManagement>
</p:properties>
</file>

<file path=customXml/itemProps1.xml><?xml version="1.0" encoding="utf-8"?>
<ds:datastoreItem xmlns:ds="http://schemas.openxmlformats.org/officeDocument/2006/customXml" ds:itemID="{8FC4FE51-5161-4521-969B-5B3EB19A5B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1ac3016-fbeb-46df-af3f-f1b6e38c419b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274E63D7-5164-4A39-B99A-59953166D91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685EAEB-209B-4ABA-84A7-FE859DE201BD}">
  <ds:schemaRefs>
    <ds:schemaRef ds:uri="f1ac3016-fbeb-46df-af3f-f1b6e38c419b"/>
    <ds:schemaRef ds:uri="http://purl.org/dc/dcmitype/"/>
    <ds:schemaRef ds:uri="http://purl.org/dc/terms/"/>
    <ds:schemaRef ds:uri="http://schemas.microsoft.com/office/2006/metadata/properties"/>
    <ds:schemaRef ds:uri="http://purl.org/dc/elements/1.1/"/>
    <ds:schemaRef ds:uri="http://schemas.microsoft.com/office/2006/documentManagement/types"/>
    <ds:schemaRef ds:uri="http://www.w3.org/XML/1998/namespace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456</TotalTime>
  <Words>661</Words>
  <Application>Microsoft Office PowerPoint</Application>
  <PresentationFormat>On-screen Show (4:3)</PresentationFormat>
  <Paragraphs>220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usty, Manas Ranjan (IRRI)</dc:creator>
  <cp:lastModifiedBy>kjena</cp:lastModifiedBy>
  <cp:revision>122</cp:revision>
  <cp:lastPrinted>2018-03-21T02:25:52Z</cp:lastPrinted>
  <dcterms:created xsi:type="dcterms:W3CDTF">2006-08-16T00:00:00Z</dcterms:created>
  <dcterms:modified xsi:type="dcterms:W3CDTF">2018-03-27T09:38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93D655ED0060C4AAC022E8E2257A357</vt:lpwstr>
  </property>
</Properties>
</file>